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7.xml" ContentType="application/vnd.openxmlformats-officedocument.presentationml.notesSl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notesSlides/notesSlide8.xml" ContentType="application/vnd.openxmlformats-officedocument.presentationml.notesSlid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notesSlides/notesSlide9.xml" ContentType="application/vnd.openxmlformats-officedocument.presentationml.notesSlide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notesSlides/notesSlide10.xml" ContentType="application/vnd.openxmlformats-officedocument.presentationml.notesSlide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3" r:id="rId2"/>
    <p:sldId id="270" r:id="rId3"/>
    <p:sldId id="278" r:id="rId4"/>
    <p:sldId id="281" r:id="rId5"/>
    <p:sldId id="264" r:id="rId6"/>
    <p:sldId id="282" r:id="rId7"/>
    <p:sldId id="276" r:id="rId8"/>
    <p:sldId id="277" r:id="rId9"/>
    <p:sldId id="283" r:id="rId10"/>
    <p:sldId id="280" r:id="rId11"/>
  </p:sldIdLst>
  <p:sldSz cx="9144000" cy="6858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204" autoAdjust="0"/>
    <p:restoredTop sz="76030" autoAdjust="0"/>
  </p:normalViewPr>
  <p:slideViewPr>
    <p:cSldViewPr>
      <p:cViewPr varScale="1">
        <p:scale>
          <a:sx n="64" d="100"/>
          <a:sy n="64" d="100"/>
        </p:scale>
        <p:origin x="-1310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Research\PhD\Data%20to%20be%20analyzed\E.coli%20Normalization%202010\E.coli%20normalization%20analysis_220510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8\2010-08-05%20Early%20time%20points%20for%20E.%20Coli%20Norm\Real%20Time%20PCR%20data%20(Ruiyang)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8\2010-08-05%20Early%20time%20points%20for%20E.%20Coli%20Norm\Real%20Time%20PCR%20data%20(Ruiyang)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1.%20Important%20files\Study\Research\Log\2010-08\2010-08-05%20Early%20time%20points%20for%20E.%20Coli%20Norm\1.%20Real%20Time%20PCR%20data%20(Ruiyang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Research\PhD\Data%20to%20be%20analyzed\E.coli%20Normalization%202010\E.coli%20normalization%20analysis_22051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tudy\Research\Log\2010-04\2010-04-28%20E.%20Coli%20Norm\2.%20Main%20Experimental%20data\RNA\E.%20coli%20Norm%20data%20RT-PCR\2010-04-28%20Expression.xlsm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cat>
            <c:strRef>
              <c:f>'Analysis Summary'!$B$38:$B$56</c:f>
              <c:strCache>
                <c:ptCount val="19"/>
                <c:pt idx="0">
                  <c:v>uxuB</c:v>
                </c:pt>
                <c:pt idx="1">
                  <c:v>rnpB</c:v>
                </c:pt>
                <c:pt idx="2">
                  <c:v>yghB</c:v>
                </c:pt>
                <c:pt idx="3">
                  <c:v>rrsA</c:v>
                </c:pt>
                <c:pt idx="4">
                  <c:v>asnA</c:v>
                </c:pt>
                <c:pt idx="5">
                  <c:v>ihfB</c:v>
                </c:pt>
                <c:pt idx="6">
                  <c:v>ugpQ</c:v>
                </c:pt>
                <c:pt idx="7">
                  <c:v>yajR</c:v>
                </c:pt>
                <c:pt idx="8">
                  <c:v>metL</c:v>
                </c:pt>
                <c:pt idx="9">
                  <c:v>ygjD</c:v>
                </c:pt>
                <c:pt idx="10">
                  <c:v>ssrA</c:v>
                </c:pt>
                <c:pt idx="11">
                  <c:v>pbpC</c:v>
                </c:pt>
                <c:pt idx="12">
                  <c:v>llcY</c:v>
                </c:pt>
                <c:pt idx="13">
                  <c:v>cca</c:v>
                </c:pt>
                <c:pt idx="14">
                  <c:v>uxuR</c:v>
                </c:pt>
                <c:pt idx="15">
                  <c:v>pflC</c:v>
                </c:pt>
                <c:pt idx="16">
                  <c:v>hcaT</c:v>
                </c:pt>
                <c:pt idx="17">
                  <c:v>cysG</c:v>
                </c:pt>
                <c:pt idx="18">
                  <c:v>ldnT</c:v>
                </c:pt>
              </c:strCache>
            </c:strRef>
          </c:cat>
          <c:val>
            <c:numRef>
              <c:f>'Analysis Summary'!$C$38:$C$56</c:f>
              <c:numCache>
                <c:formatCode>General</c:formatCode>
                <c:ptCount val="19"/>
                <c:pt idx="0">
                  <c:v>1.516</c:v>
                </c:pt>
                <c:pt idx="1">
                  <c:v>1.341</c:v>
                </c:pt>
                <c:pt idx="2">
                  <c:v>1.3129999999999951</c:v>
                </c:pt>
                <c:pt idx="3">
                  <c:v>1.302</c:v>
                </c:pt>
                <c:pt idx="4">
                  <c:v>1.2389999999999943</c:v>
                </c:pt>
                <c:pt idx="5">
                  <c:v>1.177</c:v>
                </c:pt>
                <c:pt idx="6">
                  <c:v>1.0740000000000001</c:v>
                </c:pt>
                <c:pt idx="7">
                  <c:v>1.0389999999999946</c:v>
                </c:pt>
                <c:pt idx="8">
                  <c:v>1.008</c:v>
                </c:pt>
                <c:pt idx="9">
                  <c:v>0.97900000000000065</c:v>
                </c:pt>
                <c:pt idx="10">
                  <c:v>0.93700000000000061</c:v>
                </c:pt>
                <c:pt idx="11">
                  <c:v>0.91300000000000003</c:v>
                </c:pt>
                <c:pt idx="12">
                  <c:v>0.87900000000000278</c:v>
                </c:pt>
                <c:pt idx="13">
                  <c:v>0.87100000000000244</c:v>
                </c:pt>
                <c:pt idx="14">
                  <c:v>0.85200000000000065</c:v>
                </c:pt>
                <c:pt idx="15">
                  <c:v>0.84200000000000064</c:v>
                </c:pt>
                <c:pt idx="16">
                  <c:v>0.82000000000000062</c:v>
                </c:pt>
                <c:pt idx="17">
                  <c:v>0.79</c:v>
                </c:pt>
                <c:pt idx="18">
                  <c:v>0.7890000000000000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3416448"/>
        <c:axId val="112993024"/>
      </c:lineChart>
      <c:catAx>
        <c:axId val="934164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lang="en-GB" sz="1600" b="1"/>
            </a:pPr>
            <a:endParaRPr lang="en-US"/>
          </a:p>
        </c:txPr>
        <c:crossAx val="112993024"/>
        <c:crosses val="autoZero"/>
        <c:auto val="1"/>
        <c:lblAlgn val="ctr"/>
        <c:lblOffset val="100"/>
        <c:noMultiLvlLbl val="0"/>
      </c:catAx>
      <c:valAx>
        <c:axId val="112993024"/>
        <c:scaling>
          <c:orientation val="minMax"/>
          <c:min val="0.60000000000000064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en-GB" sz="1600" b="1"/>
            </a:pPr>
            <a:endParaRPr lang="en-US"/>
          </a:p>
        </c:txPr>
        <c:crossAx val="9341644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spA expression at 28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CR$301</c:f>
              <c:strCache>
                <c:ptCount val="1"/>
                <c:pt idx="0">
                  <c:v>28C-28C Top3-isp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W$302:$CW$305</c:f>
                <c:numCache>
                  <c:formatCode>General</c:formatCode>
                  <c:ptCount val="4"/>
                  <c:pt idx="0">
                    <c:v>7.7504536219613743E-2</c:v>
                  </c:pt>
                  <c:pt idx="1">
                    <c:v>0.11946610327613219</c:v>
                  </c:pt>
                  <c:pt idx="2">
                    <c:v>7.5231635228953861E-2</c:v>
                  </c:pt>
                  <c:pt idx="3">
                    <c:v>0.11229300082391454</c:v>
                  </c:pt>
                </c:numCache>
              </c:numRef>
            </c:plus>
            <c:minus>
              <c:numRef>
                <c:f>Targ.summ!$CW$302:$CW$305</c:f>
                <c:numCache>
                  <c:formatCode>General</c:formatCode>
                  <c:ptCount val="4"/>
                  <c:pt idx="0">
                    <c:v>7.7504536219613743E-2</c:v>
                  </c:pt>
                  <c:pt idx="1">
                    <c:v>0.11946610327613219</c:v>
                  </c:pt>
                  <c:pt idx="2">
                    <c:v>7.5231635228953861E-2</c:v>
                  </c:pt>
                  <c:pt idx="3">
                    <c:v>0.11229300082391454</c:v>
                  </c:pt>
                </c:numCache>
              </c:numRef>
            </c:minus>
          </c:errBars>
          <c:cat>
            <c:strRef>
              <c:f>Targ.summ!$CQ$302:$CQ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CR$302:$CR$305</c:f>
              <c:numCache>
                <c:formatCode>General</c:formatCode>
                <c:ptCount val="4"/>
                <c:pt idx="0">
                  <c:v>0.88677533679214615</c:v>
                </c:pt>
                <c:pt idx="1">
                  <c:v>1.0188735870209658</c:v>
                </c:pt>
                <c:pt idx="2">
                  <c:v>1.0575276184966378</c:v>
                </c:pt>
                <c:pt idx="3">
                  <c:v>0.95371320051976594</c:v>
                </c:pt>
              </c:numCache>
            </c:numRef>
          </c:val>
        </c:ser>
        <c:ser>
          <c:idx val="1"/>
          <c:order val="1"/>
          <c:tx>
            <c:strRef>
              <c:f>Targ.summ!$CS$301</c:f>
              <c:strCache>
                <c:ptCount val="1"/>
                <c:pt idx="0">
                  <c:v>28C-Top3-ispA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X$302:$CX$305</c:f>
                <c:numCache>
                  <c:formatCode>General</c:formatCode>
                  <c:ptCount val="4"/>
                  <c:pt idx="0">
                    <c:v>8.329759589385731E-2</c:v>
                  </c:pt>
                  <c:pt idx="1">
                    <c:v>9.1014693151463877E-2</c:v>
                  </c:pt>
                  <c:pt idx="2">
                    <c:v>7.3365307274185415E-2</c:v>
                  </c:pt>
                  <c:pt idx="3">
                    <c:v>0.12776921620932891</c:v>
                  </c:pt>
                </c:numCache>
              </c:numRef>
            </c:plus>
            <c:minus>
              <c:numRef>
                <c:f>Targ.summ!$CX$302:$CX$305</c:f>
                <c:numCache>
                  <c:formatCode>General</c:formatCode>
                  <c:ptCount val="4"/>
                  <c:pt idx="0">
                    <c:v>8.329759589385731E-2</c:v>
                  </c:pt>
                  <c:pt idx="1">
                    <c:v>9.1014693151463877E-2</c:v>
                  </c:pt>
                  <c:pt idx="2">
                    <c:v>7.3365307274185415E-2</c:v>
                  </c:pt>
                  <c:pt idx="3">
                    <c:v>0.12776921620932891</c:v>
                  </c:pt>
                </c:numCache>
              </c:numRef>
            </c:minus>
          </c:errBars>
          <c:cat>
            <c:strRef>
              <c:f>Targ.summ!$CQ$302:$CQ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CS$302:$CS$305</c:f>
              <c:numCache>
                <c:formatCode>General</c:formatCode>
                <c:ptCount val="4"/>
                <c:pt idx="0">
                  <c:v>0.98023354200057711</c:v>
                </c:pt>
                <c:pt idx="1">
                  <c:v>0.98280527739894863</c:v>
                </c:pt>
                <c:pt idx="2">
                  <c:v>1.0066506169538481</c:v>
                </c:pt>
                <c:pt idx="3">
                  <c:v>0.99880262949372667</c:v>
                </c:pt>
              </c:numCache>
            </c:numRef>
          </c:val>
        </c:ser>
        <c:ser>
          <c:idx val="2"/>
          <c:order val="2"/>
          <c:tx>
            <c:strRef>
              <c:f>Targ.summ!$CT$301</c:f>
              <c:strCache>
                <c:ptCount val="1"/>
                <c:pt idx="0">
                  <c:v>28C-rrsA-isp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Y$302:$CY$305</c:f>
                <c:numCache>
                  <c:formatCode>General</c:formatCode>
                  <c:ptCount val="4"/>
                  <c:pt idx="0">
                    <c:v>0.10306139688536337</c:v>
                  </c:pt>
                  <c:pt idx="1">
                    <c:v>2.5311995010865018E-2</c:v>
                  </c:pt>
                  <c:pt idx="2">
                    <c:v>3.4649360366038016E-2</c:v>
                  </c:pt>
                  <c:pt idx="3">
                    <c:v>2.2007280341854403E-2</c:v>
                  </c:pt>
                </c:numCache>
              </c:numRef>
            </c:plus>
            <c:minus>
              <c:numRef>
                <c:f>Targ.summ!$CY$302:$CY$305</c:f>
                <c:numCache>
                  <c:formatCode>General</c:formatCode>
                  <c:ptCount val="4"/>
                  <c:pt idx="0">
                    <c:v>0.10306139688536337</c:v>
                  </c:pt>
                  <c:pt idx="1">
                    <c:v>2.5311995010865018E-2</c:v>
                  </c:pt>
                  <c:pt idx="2">
                    <c:v>3.4649360366038016E-2</c:v>
                  </c:pt>
                  <c:pt idx="3">
                    <c:v>2.2007280341854403E-2</c:v>
                  </c:pt>
                </c:numCache>
              </c:numRef>
            </c:minus>
          </c:errBars>
          <c:cat>
            <c:strRef>
              <c:f>Targ.summ!$CQ$302:$CQ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CT$302:$CT$305</c:f>
              <c:numCache>
                <c:formatCode>General</c:formatCode>
                <c:ptCount val="4"/>
                <c:pt idx="0">
                  <c:v>0.61358465079828661</c:v>
                </c:pt>
                <c:pt idx="1">
                  <c:v>0.16833246310136851</c:v>
                </c:pt>
                <c:pt idx="2">
                  <c:v>0.3813795025912135</c:v>
                </c:pt>
                <c:pt idx="3">
                  <c:v>0.28111660024673435</c:v>
                </c:pt>
              </c:numCache>
            </c:numRef>
          </c:val>
        </c:ser>
        <c:ser>
          <c:idx val="3"/>
          <c:order val="3"/>
          <c:tx>
            <c:strRef>
              <c:f>Targ.summ!$CU$301</c:f>
              <c:strCache>
                <c:ptCount val="1"/>
                <c:pt idx="0">
                  <c:v>28C-ihfB-isp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Z$302:$CZ$305</c:f>
                <c:numCache>
                  <c:formatCode>General</c:formatCode>
                  <c:ptCount val="4"/>
                  <c:pt idx="0">
                    <c:v>0.30476629765180896</c:v>
                  </c:pt>
                  <c:pt idx="1">
                    <c:v>0.63359068298038856</c:v>
                  </c:pt>
                  <c:pt idx="2">
                    <c:v>0.13464315513074201</c:v>
                  </c:pt>
                  <c:pt idx="3">
                    <c:v>0.74614504349279787</c:v>
                  </c:pt>
                </c:numCache>
              </c:numRef>
            </c:plus>
            <c:minus>
              <c:numRef>
                <c:f>Targ.summ!$CZ$302:$CZ$305</c:f>
                <c:numCache>
                  <c:formatCode>General</c:formatCode>
                  <c:ptCount val="4"/>
                  <c:pt idx="0">
                    <c:v>0.30476629765180896</c:v>
                  </c:pt>
                  <c:pt idx="1">
                    <c:v>0.63359068298038856</c:v>
                  </c:pt>
                  <c:pt idx="2">
                    <c:v>0.13464315513074201</c:v>
                  </c:pt>
                  <c:pt idx="3">
                    <c:v>0.74614504349279787</c:v>
                  </c:pt>
                </c:numCache>
              </c:numRef>
            </c:minus>
          </c:errBars>
          <c:cat>
            <c:strRef>
              <c:f>Targ.summ!$CQ$302:$CQ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CU$302:$CU$305</c:f>
              <c:numCache>
                <c:formatCode>General</c:formatCode>
                <c:ptCount val="4"/>
                <c:pt idx="0">
                  <c:v>1.7786341615943115</c:v>
                </c:pt>
                <c:pt idx="1">
                  <c:v>3.3405499226530737</c:v>
                </c:pt>
                <c:pt idx="2">
                  <c:v>2.2705021449668155</c:v>
                </c:pt>
                <c:pt idx="3">
                  <c:v>3.64713628820621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677824"/>
        <c:axId val="113679360"/>
      </c:barChart>
      <c:catAx>
        <c:axId val="113677824"/>
        <c:scaling>
          <c:orientation val="minMax"/>
        </c:scaling>
        <c:delete val="0"/>
        <c:axPos val="b"/>
        <c:majorTickMark val="out"/>
        <c:minorTickMark val="none"/>
        <c:tickLblPos val="low"/>
        <c:crossAx val="113679360"/>
        <c:crosses val="autoZero"/>
        <c:auto val="1"/>
        <c:lblAlgn val="ctr"/>
        <c:lblOffset val="100"/>
        <c:noMultiLvlLbl val="0"/>
      </c:catAx>
      <c:valAx>
        <c:axId val="113679360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</a:t>
                </a:r>
                <a:r>
                  <a:rPr lang="en-US" baseline="0"/>
                  <a:t> change (IPTG vs. Ctrl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367782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rrsA</a:t>
            </a:r>
            <a:r>
              <a:rPr lang="en-US" sz="1600" baseline="0"/>
              <a:t> </a:t>
            </a:r>
            <a:r>
              <a:rPr lang="en-US" sz="1600"/>
              <a:t>expression at 37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DE$251</c:f>
              <c:strCache>
                <c:ptCount val="1"/>
                <c:pt idx="0">
                  <c:v>37C-Top3-rrs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DH$252:$DH$255</c:f>
                <c:numCache>
                  <c:formatCode>General</c:formatCode>
                  <c:ptCount val="4"/>
                  <c:pt idx="0">
                    <c:v>1.4002360731802297</c:v>
                  </c:pt>
                  <c:pt idx="1">
                    <c:v>0.50711856589348248</c:v>
                  </c:pt>
                  <c:pt idx="2">
                    <c:v>0.53662159867639803</c:v>
                  </c:pt>
                  <c:pt idx="3">
                    <c:v>0.35392650577857143</c:v>
                  </c:pt>
                </c:numCache>
              </c:numRef>
            </c:plus>
            <c:minus>
              <c:numRef>
                <c:f>Targ.summ!$DH$252:$DH$255</c:f>
                <c:numCache>
                  <c:formatCode>General</c:formatCode>
                  <c:ptCount val="4"/>
                  <c:pt idx="0">
                    <c:v>1.4002360731802297</c:v>
                  </c:pt>
                  <c:pt idx="1">
                    <c:v>0.50711856589348248</c:v>
                  </c:pt>
                  <c:pt idx="2">
                    <c:v>0.53662159867639803</c:v>
                  </c:pt>
                  <c:pt idx="3">
                    <c:v>0.35392650577857143</c:v>
                  </c:pt>
                </c:numCache>
              </c:numRef>
            </c:minus>
          </c:errBars>
          <c:cat>
            <c:strRef>
              <c:f>Targ.summ!$DD$252:$DD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DE$252:$DE$255</c:f>
              <c:numCache>
                <c:formatCode>General</c:formatCode>
                <c:ptCount val="4"/>
                <c:pt idx="0">
                  <c:v>4.7799015894424404</c:v>
                </c:pt>
                <c:pt idx="1">
                  <c:v>3.1317085479302182</c:v>
                </c:pt>
                <c:pt idx="2">
                  <c:v>2.8206743830558367</c:v>
                </c:pt>
                <c:pt idx="3">
                  <c:v>2.0708281769044627</c:v>
                </c:pt>
              </c:numCache>
            </c:numRef>
          </c:val>
        </c:ser>
        <c:ser>
          <c:idx val="1"/>
          <c:order val="1"/>
          <c:tx>
            <c:strRef>
              <c:f>Targ.summ!$DF$251</c:f>
              <c:strCache>
                <c:ptCount val="1"/>
                <c:pt idx="0">
                  <c:v>37C-37C Top3-rrs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DI$252:$DI$255</c:f>
                <c:numCache>
                  <c:formatCode>General</c:formatCode>
                  <c:ptCount val="4"/>
                  <c:pt idx="0">
                    <c:v>1.4002360731802297</c:v>
                  </c:pt>
                  <c:pt idx="1">
                    <c:v>0.50711856589348259</c:v>
                  </c:pt>
                  <c:pt idx="2">
                    <c:v>0.53662159867639758</c:v>
                  </c:pt>
                  <c:pt idx="3">
                    <c:v>0.35392650577857193</c:v>
                  </c:pt>
                </c:numCache>
              </c:numRef>
            </c:plus>
            <c:minus>
              <c:numRef>
                <c:f>Targ.summ!$DI$252:$DI$255</c:f>
                <c:numCache>
                  <c:formatCode>General</c:formatCode>
                  <c:ptCount val="4"/>
                  <c:pt idx="0">
                    <c:v>1.4002360731802297</c:v>
                  </c:pt>
                  <c:pt idx="1">
                    <c:v>0.50711856589348259</c:v>
                  </c:pt>
                  <c:pt idx="2">
                    <c:v>0.53662159867639758</c:v>
                  </c:pt>
                  <c:pt idx="3">
                    <c:v>0.35392650577857193</c:v>
                  </c:pt>
                </c:numCache>
              </c:numRef>
            </c:minus>
          </c:errBars>
          <c:cat>
            <c:strRef>
              <c:f>Targ.summ!$DD$252:$DD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DF$252:$DF$255</c:f>
              <c:numCache>
                <c:formatCode>General</c:formatCode>
                <c:ptCount val="4"/>
                <c:pt idx="0">
                  <c:v>4.7799015894424404</c:v>
                </c:pt>
                <c:pt idx="1">
                  <c:v>3.1317085479302182</c:v>
                </c:pt>
                <c:pt idx="2">
                  <c:v>2.8206743830558367</c:v>
                </c:pt>
                <c:pt idx="3">
                  <c:v>2.07082817690446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745280"/>
        <c:axId val="113751168"/>
      </c:barChart>
      <c:catAx>
        <c:axId val="113745280"/>
        <c:scaling>
          <c:orientation val="minMax"/>
        </c:scaling>
        <c:delete val="0"/>
        <c:axPos val="b"/>
        <c:majorTickMark val="out"/>
        <c:minorTickMark val="none"/>
        <c:tickLblPos val="low"/>
        <c:crossAx val="113751168"/>
        <c:crosses val="autoZero"/>
        <c:auto val="1"/>
        <c:lblAlgn val="ctr"/>
        <c:lblOffset val="100"/>
        <c:noMultiLvlLbl val="0"/>
      </c:catAx>
      <c:valAx>
        <c:axId val="113751168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PTG vs. Ctr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3745280"/>
        <c:crosses val="autoZero"/>
        <c:crossBetween val="between"/>
        <c:majorUnit val="0.5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rrsA</a:t>
            </a:r>
            <a:r>
              <a:rPr lang="en-US" sz="1600" baseline="0"/>
              <a:t> </a:t>
            </a:r>
            <a:r>
              <a:rPr lang="en-US" sz="1600"/>
              <a:t>expression at 28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DE$301</c:f>
              <c:strCache>
                <c:ptCount val="1"/>
                <c:pt idx="0">
                  <c:v>28C-Top3-rrs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DH$302:$DH$305</c:f>
                <c:numCache>
                  <c:formatCode>General</c:formatCode>
                  <c:ptCount val="4"/>
                  <c:pt idx="0">
                    <c:v>0.12941856763332321</c:v>
                  </c:pt>
                  <c:pt idx="1">
                    <c:v>0.63864897343812987</c:v>
                  </c:pt>
                  <c:pt idx="2">
                    <c:v>0.31984110579596492</c:v>
                  </c:pt>
                  <c:pt idx="3">
                    <c:v>0.42156823977499686</c:v>
                  </c:pt>
                </c:numCache>
              </c:numRef>
            </c:plus>
            <c:minus>
              <c:numRef>
                <c:f>Targ.summ!$DH$302:$DH$305</c:f>
                <c:numCache>
                  <c:formatCode>General</c:formatCode>
                  <c:ptCount val="4"/>
                  <c:pt idx="0">
                    <c:v>0.12941856763332321</c:v>
                  </c:pt>
                  <c:pt idx="1">
                    <c:v>0.63864897343812987</c:v>
                  </c:pt>
                  <c:pt idx="2">
                    <c:v>0.31984110579596492</c:v>
                  </c:pt>
                  <c:pt idx="3">
                    <c:v>0.42156823977499686</c:v>
                  </c:pt>
                </c:numCache>
              </c:numRef>
            </c:minus>
          </c:errBars>
          <c:cat>
            <c:strRef>
              <c:f>Targ.summ!$DD$302:$DD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DE$302:$DE$305</c:f>
              <c:numCache>
                <c:formatCode>General</c:formatCode>
                <c:ptCount val="4"/>
                <c:pt idx="0">
                  <c:v>1.5354346079721575</c:v>
                </c:pt>
                <c:pt idx="1">
                  <c:v>5.5429983974959454</c:v>
                </c:pt>
                <c:pt idx="2">
                  <c:v>2.6857513063111456</c:v>
                </c:pt>
                <c:pt idx="3">
                  <c:v>3.5063828592772879</c:v>
                </c:pt>
              </c:numCache>
            </c:numRef>
          </c:val>
        </c:ser>
        <c:ser>
          <c:idx val="1"/>
          <c:order val="1"/>
          <c:tx>
            <c:strRef>
              <c:f>Targ.summ!$DF$301</c:f>
              <c:strCache>
                <c:ptCount val="1"/>
                <c:pt idx="0">
                  <c:v>28C-28C Top3-rrs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DI$302:$DI$305</c:f>
                <c:numCache>
                  <c:formatCode>General</c:formatCode>
                  <c:ptCount val="4"/>
                  <c:pt idx="0">
                    <c:v>0.11697015407719817</c:v>
                  </c:pt>
                  <c:pt idx="1">
                    <c:v>0.77467004106874426</c:v>
                  </c:pt>
                  <c:pt idx="2">
                    <c:v>0.35375037485724242</c:v>
                  </c:pt>
                  <c:pt idx="3">
                    <c:v>0.43462929299267006</c:v>
                  </c:pt>
                </c:numCache>
              </c:numRef>
            </c:plus>
            <c:minus>
              <c:numRef>
                <c:f>Targ.summ!$DI$302:$DI$305</c:f>
                <c:numCache>
                  <c:formatCode>General</c:formatCode>
                  <c:ptCount val="4"/>
                  <c:pt idx="0">
                    <c:v>0.11697015407719817</c:v>
                  </c:pt>
                  <c:pt idx="1">
                    <c:v>0.77467004106874426</c:v>
                  </c:pt>
                  <c:pt idx="2">
                    <c:v>0.35375037485724242</c:v>
                  </c:pt>
                  <c:pt idx="3">
                    <c:v>0.43462929299267006</c:v>
                  </c:pt>
                </c:numCache>
              </c:numRef>
            </c:minus>
          </c:errBars>
          <c:cat>
            <c:strRef>
              <c:f>Targ.summ!$DD$302:$DD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DF$302:$DF$305</c:f>
              <c:numCache>
                <c:formatCode>General</c:formatCode>
                <c:ptCount val="4"/>
                <c:pt idx="0">
                  <c:v>1.398327722910305</c:v>
                </c:pt>
                <c:pt idx="1">
                  <c:v>5.7821889535222866</c:v>
                </c:pt>
                <c:pt idx="2">
                  <c:v>2.8159048855240387</c:v>
                </c:pt>
                <c:pt idx="3">
                  <c:v>3.357444335706888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929216"/>
        <c:axId val="113935104"/>
      </c:barChart>
      <c:catAx>
        <c:axId val="113929216"/>
        <c:scaling>
          <c:orientation val="minMax"/>
        </c:scaling>
        <c:delete val="0"/>
        <c:axPos val="b"/>
        <c:majorTickMark val="out"/>
        <c:minorTickMark val="none"/>
        <c:tickLblPos val="low"/>
        <c:crossAx val="113935104"/>
        <c:crosses val="autoZero"/>
        <c:auto val="1"/>
        <c:lblAlgn val="ctr"/>
        <c:lblOffset val="100"/>
        <c:noMultiLvlLbl val="0"/>
      </c:catAx>
      <c:valAx>
        <c:axId val="113935104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PTG vs. Ctr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3929216"/>
        <c:crosses val="autoZero"/>
        <c:crossBetween val="between"/>
        <c:majorUnit val="0.5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hfB</a:t>
            </a:r>
            <a:r>
              <a:rPr lang="en-US" sz="1600" baseline="0"/>
              <a:t> </a:t>
            </a:r>
            <a:r>
              <a:rPr lang="en-US" sz="1600"/>
              <a:t>expression at 37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DR$251</c:f>
              <c:strCache>
                <c:ptCount val="1"/>
                <c:pt idx="0">
                  <c:v>37C-Top3-ihfB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DU$252:$DU$255</c:f>
                <c:numCache>
                  <c:formatCode>General</c:formatCode>
                  <c:ptCount val="4"/>
                  <c:pt idx="0">
                    <c:v>6.3523245952399041E-2</c:v>
                  </c:pt>
                  <c:pt idx="1">
                    <c:v>4.1952308920848315E-2</c:v>
                  </c:pt>
                  <c:pt idx="2">
                    <c:v>6.9560787712133379E-2</c:v>
                  </c:pt>
                  <c:pt idx="3">
                    <c:v>9.272108145861005E-2</c:v>
                  </c:pt>
                </c:numCache>
              </c:numRef>
            </c:plus>
            <c:minus>
              <c:numRef>
                <c:f>Targ.summ!$DU$252:$DU$255</c:f>
                <c:numCache>
                  <c:formatCode>General</c:formatCode>
                  <c:ptCount val="4"/>
                  <c:pt idx="0">
                    <c:v>6.3523245952399041E-2</c:v>
                  </c:pt>
                  <c:pt idx="1">
                    <c:v>4.1952308920848315E-2</c:v>
                  </c:pt>
                  <c:pt idx="2">
                    <c:v>6.9560787712133379E-2</c:v>
                  </c:pt>
                  <c:pt idx="3">
                    <c:v>9.272108145861005E-2</c:v>
                  </c:pt>
                </c:numCache>
              </c:numRef>
            </c:minus>
          </c:errBars>
          <c:cat>
            <c:strRef>
              <c:f>Targ.summ!$DQ$252:$DQ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DR$252:$DR$255</c:f>
              <c:numCache>
                <c:formatCode>General</c:formatCode>
                <c:ptCount val="4"/>
                <c:pt idx="0">
                  <c:v>0.26510642228509551</c:v>
                </c:pt>
                <c:pt idx="1">
                  <c:v>0.20002234794796467</c:v>
                </c:pt>
                <c:pt idx="2">
                  <c:v>0.36894795225536847</c:v>
                </c:pt>
                <c:pt idx="3">
                  <c:v>0.58094237756143907</c:v>
                </c:pt>
              </c:numCache>
            </c:numRef>
          </c:val>
        </c:ser>
        <c:ser>
          <c:idx val="1"/>
          <c:order val="1"/>
          <c:tx>
            <c:strRef>
              <c:f>Targ.summ!$DS$251</c:f>
              <c:strCache>
                <c:ptCount val="1"/>
                <c:pt idx="0">
                  <c:v>37C-37C Top3-ihfB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DV$252:$DV$255</c:f>
                <c:numCache>
                  <c:formatCode>General</c:formatCode>
                  <c:ptCount val="4"/>
                  <c:pt idx="0">
                    <c:v>6.3523245952399041E-2</c:v>
                  </c:pt>
                  <c:pt idx="1">
                    <c:v>4.1952308920848336E-2</c:v>
                  </c:pt>
                  <c:pt idx="2">
                    <c:v>6.9560787712133157E-2</c:v>
                  </c:pt>
                  <c:pt idx="3">
                    <c:v>9.2721081458610077E-2</c:v>
                  </c:pt>
                </c:numCache>
              </c:numRef>
            </c:plus>
            <c:minus>
              <c:numRef>
                <c:f>Targ.summ!$DV$252:$DV$255</c:f>
                <c:numCache>
                  <c:formatCode>General</c:formatCode>
                  <c:ptCount val="4"/>
                  <c:pt idx="0">
                    <c:v>6.3523245952399041E-2</c:v>
                  </c:pt>
                  <c:pt idx="1">
                    <c:v>4.1952308920848336E-2</c:v>
                  </c:pt>
                  <c:pt idx="2">
                    <c:v>6.9560787712133157E-2</c:v>
                  </c:pt>
                  <c:pt idx="3">
                    <c:v>9.2721081458610077E-2</c:v>
                  </c:pt>
                </c:numCache>
              </c:numRef>
            </c:minus>
          </c:errBars>
          <c:cat>
            <c:strRef>
              <c:f>Targ.summ!$DQ$252:$DQ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DS$252:$DS$255</c:f>
              <c:numCache>
                <c:formatCode>General</c:formatCode>
                <c:ptCount val="4"/>
                <c:pt idx="0">
                  <c:v>0.26510642228509551</c:v>
                </c:pt>
                <c:pt idx="1">
                  <c:v>0.20002234794796467</c:v>
                </c:pt>
                <c:pt idx="2">
                  <c:v>0.36894795225536847</c:v>
                </c:pt>
                <c:pt idx="3">
                  <c:v>0.580942377561438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4035328"/>
        <c:axId val="114045312"/>
      </c:barChart>
      <c:catAx>
        <c:axId val="114035328"/>
        <c:scaling>
          <c:orientation val="minMax"/>
        </c:scaling>
        <c:delete val="0"/>
        <c:axPos val="b"/>
        <c:majorTickMark val="out"/>
        <c:minorTickMark val="none"/>
        <c:tickLblPos val="low"/>
        <c:crossAx val="114045312"/>
        <c:crosses val="autoZero"/>
        <c:auto val="1"/>
        <c:lblAlgn val="ctr"/>
        <c:lblOffset val="100"/>
        <c:noMultiLvlLbl val="0"/>
      </c:catAx>
      <c:valAx>
        <c:axId val="114045312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PTG vs. Ctr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4035328"/>
        <c:crosses val="autoZero"/>
        <c:crossBetween val="between"/>
        <c:majorUnit val="0.5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hfB</a:t>
            </a:r>
            <a:r>
              <a:rPr lang="en-US" sz="1600" baseline="0"/>
              <a:t> </a:t>
            </a:r>
            <a:r>
              <a:rPr lang="en-US" sz="1600"/>
              <a:t>expression at 28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DR$301</c:f>
              <c:strCache>
                <c:ptCount val="1"/>
                <c:pt idx="0">
                  <c:v>28C-Top3-ihfB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DU$302:$DU$305</c:f>
                <c:numCache>
                  <c:formatCode>General</c:formatCode>
                  <c:ptCount val="4"/>
                  <c:pt idx="0">
                    <c:v>5.152712343343023E-2</c:v>
                  </c:pt>
                  <c:pt idx="1">
                    <c:v>3.6756836703736556E-2</c:v>
                  </c:pt>
                  <c:pt idx="2">
                    <c:v>3.6124749986767582E-2</c:v>
                  </c:pt>
                  <c:pt idx="3">
                    <c:v>2.9649037886867943E-2</c:v>
                  </c:pt>
                </c:numCache>
              </c:numRef>
            </c:plus>
            <c:minus>
              <c:numRef>
                <c:f>Targ.summ!$DU$302:$DU$305</c:f>
                <c:numCache>
                  <c:formatCode>General</c:formatCode>
                  <c:ptCount val="4"/>
                  <c:pt idx="0">
                    <c:v>5.152712343343023E-2</c:v>
                  </c:pt>
                  <c:pt idx="1">
                    <c:v>3.6756836703736556E-2</c:v>
                  </c:pt>
                  <c:pt idx="2">
                    <c:v>3.6124749986767582E-2</c:v>
                  </c:pt>
                  <c:pt idx="3">
                    <c:v>2.9649037886867943E-2</c:v>
                  </c:pt>
                </c:numCache>
              </c:numRef>
            </c:minus>
          </c:errBars>
          <c:cat>
            <c:strRef>
              <c:f>Targ.summ!$DQ$302:$DQ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DR$302:$DR$305</c:f>
              <c:numCache>
                <c:formatCode>General</c:formatCode>
                <c:ptCount val="4"/>
                <c:pt idx="0">
                  <c:v>0.56581761295404764</c:v>
                </c:pt>
                <c:pt idx="1">
                  <c:v>0.30675244858227302</c:v>
                </c:pt>
                <c:pt idx="2">
                  <c:v>0.44374537983865331</c:v>
                </c:pt>
                <c:pt idx="3">
                  <c:v>0.30012372331635723</c:v>
                </c:pt>
              </c:numCache>
            </c:numRef>
          </c:val>
        </c:ser>
        <c:ser>
          <c:idx val="1"/>
          <c:order val="1"/>
          <c:tx>
            <c:strRef>
              <c:f>Targ.summ!$DS$301</c:f>
              <c:strCache>
                <c:ptCount val="1"/>
                <c:pt idx="0">
                  <c:v>28C-28C Top3-ihfB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DV$302:$DV$305</c:f>
                <c:numCache>
                  <c:formatCode>General</c:formatCode>
                  <c:ptCount val="4"/>
                  <c:pt idx="0">
                    <c:v>4.2294204204070714E-2</c:v>
                  </c:pt>
                  <c:pt idx="1">
                    <c:v>2.7139078965670759E-2</c:v>
                  </c:pt>
                  <c:pt idx="2">
                    <c:v>3.5724899105323102E-2</c:v>
                  </c:pt>
                  <c:pt idx="3">
                    <c:v>3.2043630575382676E-2</c:v>
                  </c:pt>
                </c:numCache>
              </c:numRef>
            </c:plus>
            <c:minus>
              <c:numRef>
                <c:f>Targ.summ!$DV$302:$DV$305</c:f>
                <c:numCache>
                  <c:formatCode>General</c:formatCode>
                  <c:ptCount val="4"/>
                  <c:pt idx="0">
                    <c:v>4.2294204204070714E-2</c:v>
                  </c:pt>
                  <c:pt idx="1">
                    <c:v>2.7139078965670759E-2</c:v>
                  </c:pt>
                  <c:pt idx="2">
                    <c:v>3.5724899105323102E-2</c:v>
                  </c:pt>
                  <c:pt idx="3">
                    <c:v>3.2043630575382676E-2</c:v>
                  </c:pt>
                </c:numCache>
              </c:numRef>
            </c:minus>
          </c:errBars>
          <c:cat>
            <c:strRef>
              <c:f>Targ.summ!$DQ$302:$DQ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DS$302:$DS$305</c:f>
              <c:numCache>
                <c:formatCode>General</c:formatCode>
                <c:ptCount val="4"/>
                <c:pt idx="0">
                  <c:v>0.51897047292371778</c:v>
                </c:pt>
                <c:pt idx="1">
                  <c:v>0.31566677375040308</c:v>
                </c:pt>
                <c:pt idx="2">
                  <c:v>0.46645275963496874</c:v>
                </c:pt>
                <c:pt idx="3">
                  <c:v>0.2905730169016023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4080000"/>
        <c:axId val="114081792"/>
      </c:barChart>
      <c:catAx>
        <c:axId val="114080000"/>
        <c:scaling>
          <c:orientation val="minMax"/>
        </c:scaling>
        <c:delete val="0"/>
        <c:axPos val="b"/>
        <c:majorTickMark val="out"/>
        <c:minorTickMark val="none"/>
        <c:tickLblPos val="low"/>
        <c:crossAx val="114081792"/>
        <c:crosses val="autoZero"/>
        <c:auto val="1"/>
        <c:lblAlgn val="ctr"/>
        <c:lblOffset val="100"/>
        <c:noMultiLvlLbl val="0"/>
      </c:catAx>
      <c:valAx>
        <c:axId val="114081792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PTG vs. Ctr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4080000"/>
        <c:crosses val="autoZero"/>
        <c:crossBetween val="between"/>
        <c:majorUnit val="0.5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alculation!$S$74</c:f>
              <c:strCache>
                <c:ptCount val="1"/>
                <c:pt idx="0">
                  <c:v>rrs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alculation!$W$75:$W$77</c:f>
                <c:numCache>
                  <c:formatCode>General</c:formatCode>
                  <c:ptCount val="3"/>
                  <c:pt idx="0">
                    <c:v>0.19644259476060574</c:v>
                  </c:pt>
                  <c:pt idx="1">
                    <c:v>0.57160679742118581</c:v>
                  </c:pt>
                  <c:pt idx="2">
                    <c:v>1.6383170580759561</c:v>
                  </c:pt>
                </c:numCache>
              </c:numRef>
            </c:plus>
            <c:minus>
              <c:numRef>
                <c:f>Calculation!$W$75:$W$77</c:f>
                <c:numCache>
                  <c:formatCode>General</c:formatCode>
                  <c:ptCount val="3"/>
                  <c:pt idx="0">
                    <c:v>0.19644259476060574</c:v>
                  </c:pt>
                  <c:pt idx="1">
                    <c:v>0.57160679742118581</c:v>
                  </c:pt>
                  <c:pt idx="2">
                    <c:v>1.6383170580759561</c:v>
                  </c:pt>
                </c:numCache>
              </c:numRef>
            </c:minus>
          </c:errBars>
          <c:cat>
            <c:strRef>
              <c:f>Calculation!$Q$75:$Q$77</c:f>
              <c:strCache>
                <c:ptCount val="3"/>
                <c:pt idx="0">
                  <c:v>0.5h 0.1mM</c:v>
                </c:pt>
                <c:pt idx="1">
                  <c:v>2h 0.1mM</c:v>
                </c:pt>
                <c:pt idx="2">
                  <c:v>4h 0.1mM</c:v>
                </c:pt>
              </c:strCache>
            </c:strRef>
          </c:cat>
          <c:val>
            <c:numRef>
              <c:f>Calculation!$S$75:$S$77</c:f>
              <c:numCache>
                <c:formatCode>General</c:formatCode>
                <c:ptCount val="3"/>
                <c:pt idx="0">
                  <c:v>0.78636689928822057</c:v>
                </c:pt>
                <c:pt idx="1">
                  <c:v>4.6702524716917964</c:v>
                </c:pt>
                <c:pt idx="2">
                  <c:v>8.097517112728002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4109056"/>
        <c:axId val="114119040"/>
      </c:barChart>
      <c:catAx>
        <c:axId val="114109056"/>
        <c:scaling>
          <c:orientation val="minMax"/>
        </c:scaling>
        <c:delete val="0"/>
        <c:axPos val="b"/>
        <c:majorTickMark val="out"/>
        <c:minorTickMark val="none"/>
        <c:tickLblPos val="low"/>
        <c:crossAx val="114119040"/>
        <c:crosses val="autoZero"/>
        <c:auto val="1"/>
        <c:lblAlgn val="ctr"/>
        <c:lblOffset val="100"/>
        <c:noMultiLvlLbl val="0"/>
      </c:catAx>
      <c:valAx>
        <c:axId val="114119040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nduced vs contro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4109056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bg1">
          <a:lumMod val="50000"/>
        </a:schemeClr>
      </a:solidFill>
    </a:ln>
  </c:spPr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alculation!$T$74</c:f>
              <c:strCache>
                <c:ptCount val="1"/>
                <c:pt idx="0">
                  <c:v>ihfB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alculation!$X$75:$X$77</c:f>
                <c:numCache>
                  <c:formatCode>General</c:formatCode>
                  <c:ptCount val="3"/>
                  <c:pt idx="0">
                    <c:v>4.2880796774197684E-2</c:v>
                  </c:pt>
                  <c:pt idx="1">
                    <c:v>2.6109185252509499E-2</c:v>
                  </c:pt>
                  <c:pt idx="2">
                    <c:v>6.7856738354589302E-2</c:v>
                  </c:pt>
                </c:numCache>
              </c:numRef>
            </c:plus>
            <c:minus>
              <c:numRef>
                <c:f>Calculation!$X$75:$X$77</c:f>
                <c:numCache>
                  <c:formatCode>General</c:formatCode>
                  <c:ptCount val="3"/>
                  <c:pt idx="0">
                    <c:v>4.2880796774197684E-2</c:v>
                  </c:pt>
                  <c:pt idx="1">
                    <c:v>2.6109185252509499E-2</c:v>
                  </c:pt>
                  <c:pt idx="2">
                    <c:v>6.7856738354589302E-2</c:v>
                  </c:pt>
                </c:numCache>
              </c:numRef>
            </c:minus>
          </c:errBars>
          <c:cat>
            <c:strRef>
              <c:f>Calculation!$Q$75:$Q$77</c:f>
              <c:strCache>
                <c:ptCount val="3"/>
                <c:pt idx="0">
                  <c:v>0.5h 0.1mM</c:v>
                </c:pt>
                <c:pt idx="1">
                  <c:v>2h 0.1mM</c:v>
                </c:pt>
                <c:pt idx="2">
                  <c:v>4h 0.1mM</c:v>
                </c:pt>
              </c:strCache>
            </c:strRef>
          </c:cat>
          <c:val>
            <c:numRef>
              <c:f>Calculation!$T$75:$T$77</c:f>
              <c:numCache>
                <c:formatCode>General</c:formatCode>
                <c:ptCount val="3"/>
                <c:pt idx="0">
                  <c:v>1.0523354158107061</c:v>
                </c:pt>
                <c:pt idx="1">
                  <c:v>0.36089391540039328</c:v>
                </c:pt>
                <c:pt idx="2">
                  <c:v>0.464364918927649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4160384"/>
        <c:axId val="114161920"/>
      </c:barChart>
      <c:catAx>
        <c:axId val="114160384"/>
        <c:scaling>
          <c:orientation val="minMax"/>
        </c:scaling>
        <c:delete val="0"/>
        <c:axPos val="b"/>
        <c:majorTickMark val="out"/>
        <c:minorTickMark val="none"/>
        <c:tickLblPos val="low"/>
        <c:crossAx val="114161920"/>
        <c:crosses val="autoZero"/>
        <c:auto val="1"/>
        <c:lblAlgn val="ctr"/>
        <c:lblOffset val="100"/>
        <c:noMultiLvlLbl val="0"/>
      </c:catAx>
      <c:valAx>
        <c:axId val="114161920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nduced vs contro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416038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bg1">
          <a:lumMod val="50000"/>
        </a:schemeClr>
      </a:solidFill>
    </a:ln>
  </c:spPr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dxs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alculation!$M$117</c:f>
              <c:strCache>
                <c:ptCount val="1"/>
                <c:pt idx="0">
                  <c:v>0mM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alculation!$P$118:$P$120</c:f>
                <c:numCache>
                  <c:formatCode>General</c:formatCode>
                  <c:ptCount val="3"/>
                  <c:pt idx="0">
                    <c:v>0.12855279397737332</c:v>
                  </c:pt>
                  <c:pt idx="1">
                    <c:v>0.33085775321796768</c:v>
                  </c:pt>
                  <c:pt idx="2">
                    <c:v>0.24513869632584492</c:v>
                  </c:pt>
                </c:numCache>
              </c:numRef>
            </c:plus>
            <c:minus>
              <c:numRef>
                <c:f>Calculation!$P$118:$P$120</c:f>
                <c:numCache>
                  <c:formatCode>General</c:formatCode>
                  <c:ptCount val="3"/>
                  <c:pt idx="0">
                    <c:v>0.12855279397737332</c:v>
                  </c:pt>
                  <c:pt idx="1">
                    <c:v>0.33085775321796768</c:v>
                  </c:pt>
                  <c:pt idx="2">
                    <c:v>0.24513869632584492</c:v>
                  </c:pt>
                </c:numCache>
              </c:numRef>
            </c:minus>
          </c:errBars>
          <c:cat>
            <c:strRef>
              <c:f>Calculation!$L$118:$L$120</c:f>
              <c:strCache>
                <c:ptCount val="3"/>
                <c:pt idx="0">
                  <c:v>0.5h</c:v>
                </c:pt>
                <c:pt idx="1">
                  <c:v>2h</c:v>
                </c:pt>
                <c:pt idx="2">
                  <c:v>4h</c:v>
                </c:pt>
              </c:strCache>
            </c:strRef>
          </c:cat>
          <c:val>
            <c:numRef>
              <c:f>Calculation!$M$118:$M$120</c:f>
              <c:numCache>
                <c:formatCode>General</c:formatCode>
                <c:ptCount val="3"/>
                <c:pt idx="0">
                  <c:v>1.1481310711875354</c:v>
                </c:pt>
                <c:pt idx="1">
                  <c:v>2.5762011610619768</c:v>
                </c:pt>
                <c:pt idx="2">
                  <c:v>3.4603709206578412</c:v>
                </c:pt>
              </c:numCache>
            </c:numRef>
          </c:val>
        </c:ser>
        <c:ser>
          <c:idx val="1"/>
          <c:order val="1"/>
          <c:tx>
            <c:strRef>
              <c:f>Calculation!$N$117</c:f>
              <c:strCache>
                <c:ptCount val="1"/>
                <c:pt idx="0">
                  <c:v>0.1mM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Calculation!$Q$118:$Q$120</c:f>
                <c:numCache>
                  <c:formatCode>General</c:formatCode>
                  <c:ptCount val="3"/>
                  <c:pt idx="0">
                    <c:v>9.953100102660958</c:v>
                  </c:pt>
                  <c:pt idx="1">
                    <c:v>55.329530101201861</c:v>
                  </c:pt>
                  <c:pt idx="2">
                    <c:v>143.47251807467259</c:v>
                  </c:pt>
                </c:numCache>
              </c:numRef>
            </c:plus>
            <c:minus>
              <c:numRef>
                <c:f>Calculation!$Q$118:$Q$120</c:f>
                <c:numCache>
                  <c:formatCode>General</c:formatCode>
                  <c:ptCount val="3"/>
                  <c:pt idx="0">
                    <c:v>9.953100102660958</c:v>
                  </c:pt>
                  <c:pt idx="1">
                    <c:v>55.329530101201861</c:v>
                  </c:pt>
                  <c:pt idx="2">
                    <c:v>143.47251807467259</c:v>
                  </c:pt>
                </c:numCache>
              </c:numRef>
            </c:minus>
          </c:errBars>
          <c:cat>
            <c:strRef>
              <c:f>Calculation!$L$118:$L$120</c:f>
              <c:strCache>
                <c:ptCount val="3"/>
                <c:pt idx="0">
                  <c:v>0.5h</c:v>
                </c:pt>
                <c:pt idx="1">
                  <c:v>2h</c:v>
                </c:pt>
                <c:pt idx="2">
                  <c:v>4h</c:v>
                </c:pt>
              </c:strCache>
            </c:strRef>
          </c:cat>
          <c:val>
            <c:numRef>
              <c:f>Calculation!$N$118:$N$120</c:f>
              <c:numCache>
                <c:formatCode>General</c:formatCode>
                <c:ptCount val="3"/>
                <c:pt idx="0">
                  <c:v>106.92005755901781</c:v>
                </c:pt>
                <c:pt idx="1">
                  <c:v>501.46673530403461</c:v>
                </c:pt>
                <c:pt idx="2">
                  <c:v>604.754964194235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4205056"/>
        <c:axId val="114206592"/>
      </c:barChart>
      <c:catAx>
        <c:axId val="114205056"/>
        <c:scaling>
          <c:orientation val="minMax"/>
        </c:scaling>
        <c:delete val="0"/>
        <c:axPos val="b"/>
        <c:majorTickMark val="out"/>
        <c:minorTickMark val="none"/>
        <c:tickLblPos val="nextTo"/>
        <c:crossAx val="114206592"/>
        <c:crosses val="autoZero"/>
        <c:auto val="1"/>
        <c:lblAlgn val="ctr"/>
        <c:lblOffset val="100"/>
        <c:noMultiLvlLbl val="0"/>
      </c:catAx>
      <c:valAx>
        <c:axId val="114206592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vs 0h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420505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cat>
            <c:strRef>
              <c:f>'Analysis Summary'!$D$38:$D$56</c:f>
              <c:strCache>
                <c:ptCount val="19"/>
                <c:pt idx="0">
                  <c:v>uxuB</c:v>
                </c:pt>
                <c:pt idx="1">
                  <c:v>yghB</c:v>
                </c:pt>
                <c:pt idx="2">
                  <c:v>yajR</c:v>
                </c:pt>
                <c:pt idx="3">
                  <c:v>rnpB</c:v>
                </c:pt>
                <c:pt idx="4">
                  <c:v>asnA</c:v>
                </c:pt>
                <c:pt idx="5">
                  <c:v>rrsA</c:v>
                </c:pt>
                <c:pt idx="6">
                  <c:v>metL</c:v>
                </c:pt>
                <c:pt idx="7">
                  <c:v>ihfB</c:v>
                </c:pt>
                <c:pt idx="8">
                  <c:v>ugpQ</c:v>
                </c:pt>
                <c:pt idx="9">
                  <c:v>ssrA</c:v>
                </c:pt>
                <c:pt idx="10">
                  <c:v>pbpC</c:v>
                </c:pt>
                <c:pt idx="11">
                  <c:v>ygjD</c:v>
                </c:pt>
                <c:pt idx="12">
                  <c:v>llcY</c:v>
                </c:pt>
                <c:pt idx="13">
                  <c:v>uxuR</c:v>
                </c:pt>
                <c:pt idx="14">
                  <c:v>pflC</c:v>
                </c:pt>
                <c:pt idx="15">
                  <c:v>cca</c:v>
                </c:pt>
                <c:pt idx="16">
                  <c:v>hcaT</c:v>
                </c:pt>
                <c:pt idx="17">
                  <c:v>ldnT</c:v>
                </c:pt>
                <c:pt idx="18">
                  <c:v>cysG</c:v>
                </c:pt>
              </c:strCache>
            </c:strRef>
          </c:cat>
          <c:val>
            <c:numRef>
              <c:f>'Analysis Summary'!$E$38:$E$56</c:f>
              <c:numCache>
                <c:formatCode>0.000</c:formatCode>
                <c:ptCount val="19"/>
                <c:pt idx="0">
                  <c:v>0.59367546545506689</c:v>
                </c:pt>
                <c:pt idx="1">
                  <c:v>0.53533910087781456</c:v>
                </c:pt>
                <c:pt idx="2">
                  <c:v>0.51317469816269434</c:v>
                </c:pt>
                <c:pt idx="3">
                  <c:v>0.51176789894244756</c:v>
                </c:pt>
                <c:pt idx="4">
                  <c:v>0.50790513599344433</c:v>
                </c:pt>
                <c:pt idx="5">
                  <c:v>0.46714121137203418</c:v>
                </c:pt>
                <c:pt idx="6">
                  <c:v>0.44704490763140931</c:v>
                </c:pt>
                <c:pt idx="7">
                  <c:v>0.41758896256396244</c:v>
                </c:pt>
                <c:pt idx="8">
                  <c:v>0.39635245310953715</c:v>
                </c:pt>
                <c:pt idx="9">
                  <c:v>0.39055306782396643</c:v>
                </c:pt>
                <c:pt idx="10">
                  <c:v>0.33467805548619906</c:v>
                </c:pt>
                <c:pt idx="11">
                  <c:v>0.32565778375703092</c:v>
                </c:pt>
                <c:pt idx="12">
                  <c:v>0.27986427724436919</c:v>
                </c:pt>
                <c:pt idx="13">
                  <c:v>0.23938761784246324</c:v>
                </c:pt>
                <c:pt idx="14">
                  <c:v>0.23852577083721341</c:v>
                </c:pt>
                <c:pt idx="15">
                  <c:v>0.18388371142679691</c:v>
                </c:pt>
                <c:pt idx="16">
                  <c:v>0.17607584379047841</c:v>
                </c:pt>
                <c:pt idx="17">
                  <c:v>0.16083266621128037</c:v>
                </c:pt>
                <c:pt idx="18">
                  <c:v>0.1527632524369865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13012736"/>
        <c:axId val="113014272"/>
      </c:lineChart>
      <c:catAx>
        <c:axId val="113012736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13014272"/>
        <c:crosses val="autoZero"/>
        <c:auto val="1"/>
        <c:lblAlgn val="ctr"/>
        <c:lblOffset val="100"/>
        <c:noMultiLvlLbl val="0"/>
      </c:catAx>
      <c:valAx>
        <c:axId val="113014272"/>
        <c:scaling>
          <c:orientation val="minMax"/>
        </c:scaling>
        <c:delete val="0"/>
        <c:axPos val="l"/>
        <c:numFmt formatCode="0.00" sourceLinked="0"/>
        <c:majorTickMark val="out"/>
        <c:minorTickMark val="none"/>
        <c:tickLblPos val="nextTo"/>
        <c:txPr>
          <a:bodyPr/>
          <a:lstStyle/>
          <a:p>
            <a:pPr>
              <a:defRPr lang="en-GB"/>
            </a:pPr>
            <a:endParaRPr lang="en-US"/>
          </a:p>
        </c:txPr>
        <c:crossAx val="11301273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600" b="1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spE expression at 37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BK$251</c:f>
              <c:strCache>
                <c:ptCount val="1"/>
                <c:pt idx="0">
                  <c:v>37C-37C Top3-isp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BP$252:$BP$255</c:f>
                <c:numCache>
                  <c:formatCode>General</c:formatCode>
                  <c:ptCount val="4"/>
                  <c:pt idx="0">
                    <c:v>0.11171515767304843</c:v>
                  </c:pt>
                  <c:pt idx="1">
                    <c:v>0.11720763492889924</c:v>
                  </c:pt>
                  <c:pt idx="2">
                    <c:v>0.34631198260629442</c:v>
                  </c:pt>
                  <c:pt idx="3">
                    <c:v>0.44562775445310154</c:v>
                  </c:pt>
                </c:numCache>
              </c:numRef>
            </c:plus>
            <c:minus>
              <c:numRef>
                <c:f>Targ.summ!$BP$252:$BP$255</c:f>
                <c:numCache>
                  <c:formatCode>General</c:formatCode>
                  <c:ptCount val="4"/>
                  <c:pt idx="0">
                    <c:v>0.11171515767304843</c:v>
                  </c:pt>
                  <c:pt idx="1">
                    <c:v>0.11720763492889924</c:v>
                  </c:pt>
                  <c:pt idx="2">
                    <c:v>0.34631198260629442</c:v>
                  </c:pt>
                  <c:pt idx="3">
                    <c:v>0.44562775445310154</c:v>
                  </c:pt>
                </c:numCache>
              </c:numRef>
            </c:minus>
          </c:errBars>
          <c:cat>
            <c:strRef>
              <c:f>Targ.summ!$BJ$252:$BJ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BK$252:$BK$255</c:f>
              <c:numCache>
                <c:formatCode>General</c:formatCode>
                <c:ptCount val="4"/>
                <c:pt idx="0">
                  <c:v>0.7627643096258887</c:v>
                </c:pt>
                <c:pt idx="1">
                  <c:v>0.70723379244303364</c:v>
                </c:pt>
                <c:pt idx="2">
                  <c:v>1.8012390332747397</c:v>
                </c:pt>
                <c:pt idx="3">
                  <c:v>2.1725947255993092</c:v>
                </c:pt>
              </c:numCache>
            </c:numRef>
          </c:val>
        </c:ser>
        <c:ser>
          <c:idx val="1"/>
          <c:order val="1"/>
          <c:tx>
            <c:strRef>
              <c:f>Targ.summ!$BL$251</c:f>
              <c:strCache>
                <c:ptCount val="1"/>
                <c:pt idx="0">
                  <c:v>37C-Top3-ispE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BQ$252:$BQ$255</c:f>
                <c:numCache>
                  <c:formatCode>General</c:formatCode>
                  <c:ptCount val="4"/>
                  <c:pt idx="0">
                    <c:v>0.11171515767304843</c:v>
                  </c:pt>
                  <c:pt idx="1">
                    <c:v>0.11720763492889917</c:v>
                  </c:pt>
                  <c:pt idx="2">
                    <c:v>0.34631198260629381</c:v>
                  </c:pt>
                  <c:pt idx="3">
                    <c:v>0.44562775445310077</c:v>
                  </c:pt>
                </c:numCache>
              </c:numRef>
            </c:plus>
            <c:minus>
              <c:numRef>
                <c:f>Targ.summ!$BQ$252:$BQ$255</c:f>
                <c:numCache>
                  <c:formatCode>General</c:formatCode>
                  <c:ptCount val="4"/>
                  <c:pt idx="0">
                    <c:v>0.11171515767304843</c:v>
                  </c:pt>
                  <c:pt idx="1">
                    <c:v>0.11720763492889917</c:v>
                  </c:pt>
                  <c:pt idx="2">
                    <c:v>0.34631198260629381</c:v>
                  </c:pt>
                  <c:pt idx="3">
                    <c:v>0.44562775445310077</c:v>
                  </c:pt>
                </c:numCache>
              </c:numRef>
            </c:minus>
          </c:errBars>
          <c:cat>
            <c:strRef>
              <c:f>Targ.summ!$BJ$252:$BJ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BL$252:$BL$255</c:f>
              <c:numCache>
                <c:formatCode>General</c:formatCode>
                <c:ptCount val="4"/>
                <c:pt idx="0">
                  <c:v>0.7627643096258887</c:v>
                </c:pt>
                <c:pt idx="1">
                  <c:v>0.70723379244303364</c:v>
                </c:pt>
                <c:pt idx="2">
                  <c:v>1.8012390332747397</c:v>
                </c:pt>
                <c:pt idx="3">
                  <c:v>2.1725947255993092</c:v>
                </c:pt>
              </c:numCache>
            </c:numRef>
          </c:val>
        </c:ser>
        <c:ser>
          <c:idx val="2"/>
          <c:order val="2"/>
          <c:tx>
            <c:strRef>
              <c:f>Targ.summ!$BM$251</c:f>
              <c:strCache>
                <c:ptCount val="1"/>
                <c:pt idx="0">
                  <c:v>37C-rrsA-isp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BR$252:$BR$255</c:f>
                <c:numCache>
                  <c:formatCode>General</c:formatCode>
                  <c:ptCount val="4"/>
                  <c:pt idx="0">
                    <c:v>5.1862165229899886E-2</c:v>
                  </c:pt>
                  <c:pt idx="1">
                    <c:v>3.2541536950283841E-2</c:v>
                  </c:pt>
                  <c:pt idx="2">
                    <c:v>8.9540811838402207E-2</c:v>
                  </c:pt>
                  <c:pt idx="3">
                    <c:v>0.30060167148486255</c:v>
                  </c:pt>
                </c:numCache>
              </c:numRef>
            </c:plus>
            <c:minus>
              <c:numRef>
                <c:f>Targ.summ!$BR$252:$BR$255</c:f>
                <c:numCache>
                  <c:formatCode>General</c:formatCode>
                  <c:ptCount val="4"/>
                  <c:pt idx="0">
                    <c:v>5.1862165229899886E-2</c:v>
                  </c:pt>
                  <c:pt idx="1">
                    <c:v>3.2541536950283841E-2</c:v>
                  </c:pt>
                  <c:pt idx="2">
                    <c:v>8.9540811838402207E-2</c:v>
                  </c:pt>
                  <c:pt idx="3">
                    <c:v>0.30060167148486255</c:v>
                  </c:pt>
                </c:numCache>
              </c:numRef>
            </c:minus>
          </c:errBars>
          <c:cat>
            <c:strRef>
              <c:f>Targ.summ!$BJ$252:$BJ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BM$252:$BM$255</c:f>
              <c:numCache>
                <c:formatCode>General</c:formatCode>
                <c:ptCount val="4"/>
                <c:pt idx="0">
                  <c:v>0.18871764310955624</c:v>
                </c:pt>
                <c:pt idx="1">
                  <c:v>0.22000838779346296</c:v>
                </c:pt>
                <c:pt idx="2">
                  <c:v>0.66128411133140064</c:v>
                </c:pt>
                <c:pt idx="3">
                  <c:v>1.1511464737570061</c:v>
                </c:pt>
              </c:numCache>
            </c:numRef>
          </c:val>
        </c:ser>
        <c:ser>
          <c:idx val="3"/>
          <c:order val="3"/>
          <c:tx>
            <c:strRef>
              <c:f>Targ.summ!$BN$251</c:f>
              <c:strCache>
                <c:ptCount val="1"/>
                <c:pt idx="0">
                  <c:v>37C-ihfB-isp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BS$252:$BS$255</c:f>
                <c:numCache>
                  <c:formatCode>General</c:formatCode>
                  <c:ptCount val="4"/>
                  <c:pt idx="0">
                    <c:v>0.61932764408632923</c:v>
                  </c:pt>
                  <c:pt idx="1">
                    <c:v>0.87561953882474564</c:v>
                  </c:pt>
                  <c:pt idx="2">
                    <c:v>0.93161379657970178</c:v>
                  </c:pt>
                  <c:pt idx="3">
                    <c:v>0.6676783260729009</c:v>
                  </c:pt>
                </c:numCache>
              </c:numRef>
            </c:plus>
            <c:minus>
              <c:numRef>
                <c:f>Targ.summ!$BS$252:$BS$255</c:f>
                <c:numCache>
                  <c:formatCode>General</c:formatCode>
                  <c:ptCount val="4"/>
                  <c:pt idx="0">
                    <c:v>0.61932764408632923</c:v>
                  </c:pt>
                  <c:pt idx="1">
                    <c:v>0.87561953882474564</c:v>
                  </c:pt>
                  <c:pt idx="2">
                    <c:v>0.93161379657970178</c:v>
                  </c:pt>
                  <c:pt idx="3">
                    <c:v>0.6676783260729009</c:v>
                  </c:pt>
                </c:numCache>
              </c:numRef>
            </c:minus>
          </c:errBars>
          <c:cat>
            <c:strRef>
              <c:f>Targ.summ!$BJ$252:$BJ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BN$252:$BN$255</c:f>
              <c:numCache>
                <c:formatCode>General</c:formatCode>
                <c:ptCount val="4"/>
                <c:pt idx="0">
                  <c:v>3.1818403507993009</c:v>
                </c:pt>
                <c:pt idx="1">
                  <c:v>3.881527328655014</c:v>
                </c:pt>
                <c:pt idx="2">
                  <c:v>5.0788645878001724</c:v>
                </c:pt>
                <c:pt idx="3">
                  <c:v>3.796023894963763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210496"/>
        <c:axId val="113212032"/>
      </c:barChart>
      <c:catAx>
        <c:axId val="113210496"/>
        <c:scaling>
          <c:orientation val="minMax"/>
        </c:scaling>
        <c:delete val="0"/>
        <c:axPos val="b"/>
        <c:majorTickMark val="out"/>
        <c:minorTickMark val="none"/>
        <c:tickLblPos val="low"/>
        <c:crossAx val="113212032"/>
        <c:crosses val="autoZero"/>
        <c:auto val="1"/>
        <c:lblAlgn val="ctr"/>
        <c:lblOffset val="100"/>
        <c:noMultiLvlLbl val="0"/>
      </c:catAx>
      <c:valAx>
        <c:axId val="113212032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PTG vs. Ctr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3210496"/>
        <c:crosses val="autoZero"/>
        <c:crossBetween val="between"/>
        <c:majorUnit val="0.5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spE expression at 28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BK$301</c:f>
              <c:strCache>
                <c:ptCount val="1"/>
                <c:pt idx="0">
                  <c:v>28C-28C Top3-isp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BP$302:$BP$305</c:f>
                <c:numCache>
                  <c:formatCode>General</c:formatCode>
                  <c:ptCount val="4"/>
                  <c:pt idx="0">
                    <c:v>6.5784488311912429E-2</c:v>
                  </c:pt>
                  <c:pt idx="1">
                    <c:v>5.1169048807868447E-2</c:v>
                  </c:pt>
                  <c:pt idx="2">
                    <c:v>6.6303093706562038E-2</c:v>
                  </c:pt>
                  <c:pt idx="3">
                    <c:v>3.817013563897461E-2</c:v>
                  </c:pt>
                </c:numCache>
              </c:numRef>
            </c:plus>
            <c:minus>
              <c:numRef>
                <c:f>Targ.summ!$BP$302:$BP$305</c:f>
                <c:numCache>
                  <c:formatCode>General</c:formatCode>
                  <c:ptCount val="4"/>
                  <c:pt idx="0">
                    <c:v>6.5784488311912429E-2</c:v>
                  </c:pt>
                  <c:pt idx="1">
                    <c:v>5.1169048807868447E-2</c:v>
                  </c:pt>
                  <c:pt idx="2">
                    <c:v>6.6303093706562038E-2</c:v>
                  </c:pt>
                  <c:pt idx="3">
                    <c:v>3.817013563897461E-2</c:v>
                  </c:pt>
                </c:numCache>
              </c:numRef>
            </c:minus>
          </c:errBars>
          <c:cat>
            <c:strRef>
              <c:f>Targ.summ!$BJ$302:$BJ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BK$302:$BK$305</c:f>
              <c:numCache>
                <c:formatCode>General</c:formatCode>
                <c:ptCount val="4"/>
                <c:pt idx="0">
                  <c:v>0.80500679235741568</c:v>
                </c:pt>
                <c:pt idx="1">
                  <c:v>0.78405405924621452</c:v>
                </c:pt>
                <c:pt idx="2">
                  <c:v>0.64703353968883992</c:v>
                </c:pt>
                <c:pt idx="3">
                  <c:v>0.68918267683567669</c:v>
                </c:pt>
              </c:numCache>
            </c:numRef>
          </c:val>
        </c:ser>
        <c:ser>
          <c:idx val="1"/>
          <c:order val="1"/>
          <c:tx>
            <c:strRef>
              <c:f>Targ.summ!$BL$301</c:f>
              <c:strCache>
                <c:ptCount val="1"/>
                <c:pt idx="0">
                  <c:v>28C-Top3-ispE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BQ$302:$BQ$305</c:f>
                <c:numCache>
                  <c:formatCode>General</c:formatCode>
                  <c:ptCount val="4"/>
                  <c:pt idx="0">
                    <c:v>8.3136505873675715E-2</c:v>
                  </c:pt>
                  <c:pt idx="1">
                    <c:v>6.6110594083199012E-2</c:v>
                  </c:pt>
                  <c:pt idx="2">
                    <c:v>6.2896428769531623E-2</c:v>
                  </c:pt>
                  <c:pt idx="3">
                    <c:v>2.5909864183841454E-2</c:v>
                  </c:pt>
                </c:numCache>
              </c:numRef>
            </c:plus>
            <c:minus>
              <c:numRef>
                <c:f>Targ.summ!$BQ$302:$BQ$305</c:f>
                <c:numCache>
                  <c:formatCode>General</c:formatCode>
                  <c:ptCount val="4"/>
                  <c:pt idx="0">
                    <c:v>8.3136505873675715E-2</c:v>
                  </c:pt>
                  <c:pt idx="1">
                    <c:v>6.6110594083199012E-2</c:v>
                  </c:pt>
                  <c:pt idx="2">
                    <c:v>6.2896428769531623E-2</c:v>
                  </c:pt>
                  <c:pt idx="3">
                    <c:v>2.5909864183841454E-2</c:v>
                  </c:pt>
                </c:numCache>
              </c:numRef>
            </c:minus>
          </c:errBars>
          <c:cat>
            <c:strRef>
              <c:f>Targ.summ!$BJ$302:$BJ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BL$302:$BL$305</c:f>
              <c:numCache>
                <c:formatCode>General</c:formatCode>
                <c:ptCount val="4"/>
                <c:pt idx="0">
                  <c:v>0.87644371026460677</c:v>
                </c:pt>
                <c:pt idx="1">
                  <c:v>0.75334040121478341</c:v>
                </c:pt>
                <c:pt idx="2">
                  <c:v>0.61630583125451777</c:v>
                </c:pt>
                <c:pt idx="3">
                  <c:v>0.71545457925685718</c:v>
                </c:pt>
              </c:numCache>
            </c:numRef>
          </c:val>
        </c:ser>
        <c:ser>
          <c:idx val="2"/>
          <c:order val="2"/>
          <c:tx>
            <c:strRef>
              <c:f>Targ.summ!$BM$301</c:f>
              <c:strCache>
                <c:ptCount val="1"/>
                <c:pt idx="0">
                  <c:v>28C-rrsA-ispE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BR$302:$BR$305</c:f>
                <c:numCache>
                  <c:formatCode>General</c:formatCode>
                  <c:ptCount val="4"/>
                  <c:pt idx="0">
                    <c:v>5.9116337119397303E-2</c:v>
                  </c:pt>
                  <c:pt idx="1">
                    <c:v>2.0032836185411892E-2</c:v>
                  </c:pt>
                  <c:pt idx="2">
                    <c:v>2.5000922971581459E-2</c:v>
                  </c:pt>
                  <c:pt idx="3">
                    <c:v>2.5103088195952958E-2</c:v>
                  </c:pt>
                </c:numCache>
              </c:numRef>
            </c:plus>
            <c:minus>
              <c:numRef>
                <c:f>Targ.summ!$BR$302:$BR$305</c:f>
                <c:numCache>
                  <c:formatCode>General</c:formatCode>
                  <c:ptCount val="4"/>
                  <c:pt idx="0">
                    <c:v>5.9116337119397303E-2</c:v>
                  </c:pt>
                  <c:pt idx="1">
                    <c:v>2.0032836185411892E-2</c:v>
                  </c:pt>
                  <c:pt idx="2">
                    <c:v>2.5000922971581459E-2</c:v>
                  </c:pt>
                  <c:pt idx="3">
                    <c:v>2.5103088195952958E-2</c:v>
                  </c:pt>
                </c:numCache>
              </c:numRef>
            </c:minus>
          </c:errBars>
          <c:cat>
            <c:strRef>
              <c:f>Targ.summ!$BJ$302:$BJ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BM$302:$BM$305</c:f>
              <c:numCache>
                <c:formatCode>General</c:formatCode>
                <c:ptCount val="4"/>
                <c:pt idx="0">
                  <c:v>0.55677053124195486</c:v>
                </c:pt>
                <c:pt idx="1">
                  <c:v>0.13692514569233696</c:v>
                </c:pt>
                <c:pt idx="2">
                  <c:v>0.23070428341918342</c:v>
                </c:pt>
                <c:pt idx="3">
                  <c:v>0.21195730511188979</c:v>
                </c:pt>
              </c:numCache>
            </c:numRef>
          </c:val>
        </c:ser>
        <c:ser>
          <c:idx val="3"/>
          <c:order val="3"/>
          <c:tx>
            <c:strRef>
              <c:f>Targ.summ!$BN$301</c:f>
              <c:strCache>
                <c:ptCount val="1"/>
                <c:pt idx="0">
                  <c:v>28C-ihfB-isp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BS$302:$BS$305</c:f>
                <c:numCache>
                  <c:formatCode>General</c:formatCode>
                  <c:ptCount val="4"/>
                  <c:pt idx="0">
                    <c:v>6.3417494194650134E-2</c:v>
                  </c:pt>
                  <c:pt idx="1">
                    <c:v>0.2279885397930467</c:v>
                  </c:pt>
                  <c:pt idx="2">
                    <c:v>7.7452057668410484E-2</c:v>
                  </c:pt>
                  <c:pt idx="3">
                    <c:v>0.25643916410709794</c:v>
                  </c:pt>
                </c:numCache>
              </c:numRef>
            </c:plus>
            <c:minus>
              <c:numRef>
                <c:f>Targ.summ!$BS$302:$BS$305</c:f>
                <c:numCache>
                  <c:formatCode>General</c:formatCode>
                  <c:ptCount val="4"/>
                  <c:pt idx="0">
                    <c:v>6.3417494194650134E-2</c:v>
                  </c:pt>
                  <c:pt idx="1">
                    <c:v>0.2279885397930467</c:v>
                  </c:pt>
                  <c:pt idx="2">
                    <c:v>7.7452057668410484E-2</c:v>
                  </c:pt>
                  <c:pt idx="3">
                    <c:v>0.25643916410709794</c:v>
                  </c:pt>
                </c:numCache>
              </c:numRef>
            </c:minus>
          </c:errBars>
          <c:cat>
            <c:strRef>
              <c:f>Targ.summ!$BJ$302:$BJ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BN$302:$BN$305</c:f>
              <c:numCache>
                <c:formatCode>General</c:formatCode>
                <c:ptCount val="4"/>
                <c:pt idx="0">
                  <c:v>1.566850700153352</c:v>
                </c:pt>
                <c:pt idx="1">
                  <c:v>2.5492564265953739</c:v>
                </c:pt>
                <c:pt idx="2">
                  <c:v>1.3807265444919821</c:v>
                </c:pt>
                <c:pt idx="3">
                  <c:v>2.50239909609465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327104"/>
        <c:axId val="113328896"/>
      </c:barChart>
      <c:catAx>
        <c:axId val="113327104"/>
        <c:scaling>
          <c:orientation val="minMax"/>
        </c:scaling>
        <c:delete val="0"/>
        <c:axPos val="b"/>
        <c:majorTickMark val="out"/>
        <c:minorTickMark val="none"/>
        <c:tickLblPos val="low"/>
        <c:crossAx val="113328896"/>
        <c:crosses val="autoZero"/>
        <c:auto val="1"/>
        <c:lblAlgn val="ctr"/>
        <c:lblOffset val="100"/>
        <c:noMultiLvlLbl val="0"/>
      </c:catAx>
      <c:valAx>
        <c:axId val="113328896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</a:t>
                </a:r>
                <a:r>
                  <a:rPr lang="en-US" baseline="0"/>
                  <a:t> change (IPTG vs. Ctrl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low"/>
        <c:crossAx val="11332710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spG expression at 37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BV$251</c:f>
              <c:strCache>
                <c:ptCount val="1"/>
                <c:pt idx="0">
                  <c:v>37C-37C Top3-ispG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A$252:$CA$255</c:f>
                <c:numCache>
                  <c:formatCode>General</c:formatCode>
                  <c:ptCount val="4"/>
                  <c:pt idx="0">
                    <c:v>4.6866926375042993E-2</c:v>
                  </c:pt>
                  <c:pt idx="1">
                    <c:v>8.185115779750568E-2</c:v>
                  </c:pt>
                  <c:pt idx="2">
                    <c:v>0.42235536345821373</c:v>
                  </c:pt>
                  <c:pt idx="3">
                    <c:v>0.59442137835182052</c:v>
                  </c:pt>
                </c:numCache>
              </c:numRef>
            </c:plus>
            <c:minus>
              <c:numRef>
                <c:f>Targ.summ!$CA$252:$CA$255</c:f>
                <c:numCache>
                  <c:formatCode>General</c:formatCode>
                  <c:ptCount val="4"/>
                  <c:pt idx="0">
                    <c:v>4.6866926375042993E-2</c:v>
                  </c:pt>
                  <c:pt idx="1">
                    <c:v>8.185115779750568E-2</c:v>
                  </c:pt>
                  <c:pt idx="2">
                    <c:v>0.42235536345821373</c:v>
                  </c:pt>
                  <c:pt idx="3">
                    <c:v>0.59442137835182052</c:v>
                  </c:pt>
                </c:numCache>
              </c:numRef>
            </c:minus>
          </c:errBars>
          <c:cat>
            <c:strRef>
              <c:f>Targ.summ!$BU$252:$BU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BV$252:$BV$255</c:f>
              <c:numCache>
                <c:formatCode>General</c:formatCode>
                <c:ptCount val="4"/>
                <c:pt idx="0">
                  <c:v>0.71508067961961963</c:v>
                </c:pt>
                <c:pt idx="1">
                  <c:v>1.2696082180624357</c:v>
                </c:pt>
                <c:pt idx="2">
                  <c:v>1.5912671149973461</c:v>
                </c:pt>
                <c:pt idx="3">
                  <c:v>2.1846869482447402</c:v>
                </c:pt>
              </c:numCache>
            </c:numRef>
          </c:val>
        </c:ser>
        <c:ser>
          <c:idx val="1"/>
          <c:order val="1"/>
          <c:tx>
            <c:strRef>
              <c:f>Targ.summ!$BW$251</c:f>
              <c:strCache>
                <c:ptCount val="1"/>
                <c:pt idx="0">
                  <c:v>37C-Top3-ispG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B$252:$CB$255</c:f>
                <c:numCache>
                  <c:formatCode>General</c:formatCode>
                  <c:ptCount val="4"/>
                  <c:pt idx="0">
                    <c:v>4.6866926375042993E-2</c:v>
                  </c:pt>
                  <c:pt idx="1">
                    <c:v>8.1851157797504626E-2</c:v>
                  </c:pt>
                  <c:pt idx="2">
                    <c:v>0.4223553634582134</c:v>
                  </c:pt>
                  <c:pt idx="3">
                    <c:v>0.5944213783518203</c:v>
                  </c:pt>
                </c:numCache>
              </c:numRef>
            </c:plus>
            <c:minus>
              <c:numRef>
                <c:f>Targ.summ!$CB$252:$CB$255</c:f>
                <c:numCache>
                  <c:formatCode>General</c:formatCode>
                  <c:ptCount val="4"/>
                  <c:pt idx="0">
                    <c:v>4.6866926375042993E-2</c:v>
                  </c:pt>
                  <c:pt idx="1">
                    <c:v>8.1851157797504626E-2</c:v>
                  </c:pt>
                  <c:pt idx="2">
                    <c:v>0.4223553634582134</c:v>
                  </c:pt>
                  <c:pt idx="3">
                    <c:v>0.5944213783518203</c:v>
                  </c:pt>
                </c:numCache>
              </c:numRef>
            </c:minus>
          </c:errBars>
          <c:cat>
            <c:strRef>
              <c:f>Targ.summ!$BU$252:$BU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BW$252:$BW$255</c:f>
              <c:numCache>
                <c:formatCode>General</c:formatCode>
                <c:ptCount val="4"/>
                <c:pt idx="0">
                  <c:v>0.71508067961961963</c:v>
                </c:pt>
                <c:pt idx="1">
                  <c:v>1.2696082180624357</c:v>
                </c:pt>
                <c:pt idx="2">
                  <c:v>1.5912671149973461</c:v>
                </c:pt>
                <c:pt idx="3">
                  <c:v>2.1846869482447402</c:v>
                </c:pt>
              </c:numCache>
            </c:numRef>
          </c:val>
        </c:ser>
        <c:ser>
          <c:idx val="2"/>
          <c:order val="2"/>
          <c:tx>
            <c:strRef>
              <c:f>Targ.summ!$BX$251</c:f>
              <c:strCache>
                <c:ptCount val="1"/>
                <c:pt idx="0">
                  <c:v>37C-rrsA-isp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C$252:$CC$255</c:f>
                <c:numCache>
                  <c:formatCode>General</c:formatCode>
                  <c:ptCount val="4"/>
                  <c:pt idx="0">
                    <c:v>4.5517988537657303E-2</c:v>
                  </c:pt>
                  <c:pt idx="1">
                    <c:v>5.6156737978508821E-2</c:v>
                  </c:pt>
                  <c:pt idx="2">
                    <c:v>0.14012734254438694</c:v>
                  </c:pt>
                  <c:pt idx="3">
                    <c:v>0.37733301073901782</c:v>
                  </c:pt>
                </c:numCache>
              </c:numRef>
            </c:plus>
            <c:minus>
              <c:numRef>
                <c:f>Targ.summ!$CC$252:$CC$255</c:f>
                <c:numCache>
                  <c:formatCode>General</c:formatCode>
                  <c:ptCount val="4"/>
                  <c:pt idx="0">
                    <c:v>4.5517988537657303E-2</c:v>
                  </c:pt>
                  <c:pt idx="1">
                    <c:v>5.6156737978508821E-2</c:v>
                  </c:pt>
                  <c:pt idx="2">
                    <c:v>0.14012734254438694</c:v>
                  </c:pt>
                  <c:pt idx="3">
                    <c:v>0.37733301073901782</c:v>
                  </c:pt>
                </c:numCache>
              </c:numRef>
            </c:minus>
          </c:errBars>
          <c:cat>
            <c:strRef>
              <c:f>Targ.summ!$BU$252:$BU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BX$252:$BX$255</c:f>
              <c:numCache>
                <c:formatCode>General</c:formatCode>
                <c:ptCount val="4"/>
                <c:pt idx="0">
                  <c:v>0.17066015736136941</c:v>
                </c:pt>
                <c:pt idx="1">
                  <c:v>0.38619988635125124</c:v>
                </c:pt>
                <c:pt idx="2">
                  <c:v>0.58502511466453</c:v>
                </c:pt>
                <c:pt idx="3">
                  <c:v>1.1471370776692957</c:v>
                </c:pt>
              </c:numCache>
            </c:numRef>
          </c:val>
        </c:ser>
        <c:ser>
          <c:idx val="3"/>
          <c:order val="3"/>
          <c:tx>
            <c:strRef>
              <c:f>Targ.summ!$BY$251</c:f>
              <c:strCache>
                <c:ptCount val="1"/>
                <c:pt idx="0">
                  <c:v>37C-ihfB-isp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D$252:$CD$255</c:f>
                <c:numCache>
                  <c:formatCode>General</c:formatCode>
                  <c:ptCount val="4"/>
                  <c:pt idx="0">
                    <c:v>0.58490976835743458</c:v>
                  </c:pt>
                  <c:pt idx="1">
                    <c:v>1.5822728893353184</c:v>
                  </c:pt>
                  <c:pt idx="2">
                    <c:v>0.68707200640388855</c:v>
                  </c:pt>
                  <c:pt idx="3">
                    <c:v>0.72004696902417664</c:v>
                  </c:pt>
                </c:numCache>
              </c:numRef>
            </c:plus>
            <c:minus>
              <c:numRef>
                <c:f>Targ.summ!$CD$252:$CD$255</c:f>
                <c:numCache>
                  <c:formatCode>General</c:formatCode>
                  <c:ptCount val="4"/>
                  <c:pt idx="0">
                    <c:v>0.58490976835743458</c:v>
                  </c:pt>
                  <c:pt idx="1">
                    <c:v>1.5822728893353184</c:v>
                  </c:pt>
                  <c:pt idx="2">
                    <c:v>0.68707200640388855</c:v>
                  </c:pt>
                  <c:pt idx="3">
                    <c:v>0.72004696902417664</c:v>
                  </c:pt>
                </c:numCache>
              </c:numRef>
            </c:minus>
          </c:errBars>
          <c:cat>
            <c:strRef>
              <c:f>Targ.summ!$BU$252:$BU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BY$252:$BY$255</c:f>
              <c:numCache>
                <c:formatCode>General</c:formatCode>
                <c:ptCount val="4"/>
                <c:pt idx="0">
                  <c:v>2.6952343800357403</c:v>
                </c:pt>
                <c:pt idx="1">
                  <c:v>6.3827246526026462</c:v>
                </c:pt>
                <c:pt idx="2">
                  <c:v>4.5202070263158696</c:v>
                </c:pt>
                <c:pt idx="3">
                  <c:v>3.90629060764466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378432"/>
        <c:axId val="113379968"/>
      </c:barChart>
      <c:catAx>
        <c:axId val="113378432"/>
        <c:scaling>
          <c:orientation val="minMax"/>
        </c:scaling>
        <c:delete val="0"/>
        <c:axPos val="b"/>
        <c:majorTickMark val="out"/>
        <c:minorTickMark val="none"/>
        <c:tickLblPos val="low"/>
        <c:crossAx val="113379968"/>
        <c:crosses val="autoZero"/>
        <c:auto val="1"/>
        <c:lblAlgn val="ctr"/>
        <c:lblOffset val="100"/>
        <c:noMultiLvlLbl val="0"/>
      </c:catAx>
      <c:valAx>
        <c:axId val="113379968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PTG vs. Ctr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3378432"/>
        <c:crosses val="autoZero"/>
        <c:crossBetween val="between"/>
        <c:majorUnit val="0.5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spG expression at 28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BV$301</c:f>
              <c:strCache>
                <c:ptCount val="1"/>
                <c:pt idx="0">
                  <c:v>28C-28C Top3-ispG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A$302:$CA$305</c:f>
                <c:numCache>
                  <c:formatCode>General</c:formatCode>
                  <c:ptCount val="4"/>
                  <c:pt idx="0">
                    <c:v>4.3444184994261108E-2</c:v>
                  </c:pt>
                  <c:pt idx="1">
                    <c:v>7.5604502380596628E-2</c:v>
                  </c:pt>
                  <c:pt idx="2">
                    <c:v>5.8411701040830093E-2</c:v>
                  </c:pt>
                  <c:pt idx="3">
                    <c:v>2.8936261734408317E-2</c:v>
                  </c:pt>
                </c:numCache>
              </c:numRef>
            </c:plus>
            <c:minus>
              <c:numRef>
                <c:f>Targ.summ!$CA$302:$CA$305</c:f>
                <c:numCache>
                  <c:formatCode>General</c:formatCode>
                  <c:ptCount val="4"/>
                  <c:pt idx="0">
                    <c:v>4.3444184994261108E-2</c:v>
                  </c:pt>
                  <c:pt idx="1">
                    <c:v>7.5604502380596628E-2</c:v>
                  </c:pt>
                  <c:pt idx="2">
                    <c:v>5.8411701040830093E-2</c:v>
                  </c:pt>
                  <c:pt idx="3">
                    <c:v>2.8936261734408317E-2</c:v>
                  </c:pt>
                </c:numCache>
              </c:numRef>
            </c:minus>
          </c:errBars>
          <c:cat>
            <c:strRef>
              <c:f>Targ.summ!$BU$302:$BU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BV$302:$BV$305</c:f>
              <c:numCache>
                <c:formatCode>General</c:formatCode>
                <c:ptCount val="4"/>
                <c:pt idx="0">
                  <c:v>0.70081929703042789</c:v>
                </c:pt>
                <c:pt idx="1">
                  <c:v>0.89321898108893538</c:v>
                </c:pt>
                <c:pt idx="2">
                  <c:v>0.64330558465998355</c:v>
                </c:pt>
                <c:pt idx="3">
                  <c:v>0.82740935688363471</c:v>
                </c:pt>
              </c:numCache>
            </c:numRef>
          </c:val>
        </c:ser>
        <c:ser>
          <c:idx val="1"/>
          <c:order val="1"/>
          <c:tx>
            <c:strRef>
              <c:f>Targ.summ!$BW$301</c:f>
              <c:strCache>
                <c:ptCount val="1"/>
                <c:pt idx="0">
                  <c:v>28C-Top3-ispG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B$302:$CB$305</c:f>
                <c:numCache>
                  <c:formatCode>General</c:formatCode>
                  <c:ptCount val="4"/>
                  <c:pt idx="0">
                    <c:v>5.3759935203764292E-2</c:v>
                  </c:pt>
                  <c:pt idx="1">
                    <c:v>6.4732602823805899E-2</c:v>
                  </c:pt>
                  <c:pt idx="2">
                    <c:v>5.9336195303291921E-2</c:v>
                  </c:pt>
                  <c:pt idx="3">
                    <c:v>4.6860563015144484E-2</c:v>
                  </c:pt>
                </c:numCache>
              </c:numRef>
            </c:plus>
            <c:minus>
              <c:numRef>
                <c:f>Targ.summ!$CB$302:$CB$305</c:f>
                <c:numCache>
                  <c:formatCode>General</c:formatCode>
                  <c:ptCount val="4"/>
                  <c:pt idx="0">
                    <c:v>5.3759935203764292E-2</c:v>
                  </c:pt>
                  <c:pt idx="1">
                    <c:v>6.4732602823805899E-2</c:v>
                  </c:pt>
                  <c:pt idx="2">
                    <c:v>5.9336195303291921E-2</c:v>
                  </c:pt>
                  <c:pt idx="3">
                    <c:v>4.6860563015144484E-2</c:v>
                  </c:pt>
                </c:numCache>
              </c:numRef>
            </c:minus>
          </c:errBars>
          <c:cat>
            <c:strRef>
              <c:f>Targ.summ!$BU$302:$BU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BW$302:$BW$305</c:f>
              <c:numCache>
                <c:formatCode>General</c:formatCode>
                <c:ptCount val="4"/>
                <c:pt idx="0">
                  <c:v>0.76633983887519208</c:v>
                </c:pt>
                <c:pt idx="1">
                  <c:v>0.85623233720732528</c:v>
                </c:pt>
                <c:pt idx="2">
                  <c:v>0.60766381027599148</c:v>
                </c:pt>
                <c:pt idx="3">
                  <c:v>0.85605790335792997</c:v>
                </c:pt>
              </c:numCache>
            </c:numRef>
          </c:val>
        </c:ser>
        <c:ser>
          <c:idx val="2"/>
          <c:order val="2"/>
          <c:tx>
            <c:strRef>
              <c:f>Targ.summ!$BX$301</c:f>
              <c:strCache>
                <c:ptCount val="1"/>
                <c:pt idx="0">
                  <c:v>28C-rrsA-isp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C$302:$CC$305</c:f>
                <c:numCache>
                  <c:formatCode>General</c:formatCode>
                  <c:ptCount val="4"/>
                  <c:pt idx="0">
                    <c:v>4.0331222446513194E-2</c:v>
                  </c:pt>
                  <c:pt idx="1">
                    <c:v>1.2472566627713521E-2</c:v>
                  </c:pt>
                  <c:pt idx="2">
                    <c:v>4.7087555170602209E-2</c:v>
                  </c:pt>
                  <c:pt idx="3">
                    <c:v>3.5083894518028416E-2</c:v>
                  </c:pt>
                </c:numCache>
              </c:numRef>
            </c:plus>
            <c:minus>
              <c:numRef>
                <c:f>Targ.summ!$CC$302:$CC$305</c:f>
                <c:numCache>
                  <c:formatCode>General</c:formatCode>
                  <c:ptCount val="4"/>
                  <c:pt idx="0">
                    <c:v>4.0331222446513194E-2</c:v>
                  </c:pt>
                  <c:pt idx="1">
                    <c:v>1.2472566627713521E-2</c:v>
                  </c:pt>
                  <c:pt idx="2">
                    <c:v>4.7087555170602209E-2</c:v>
                  </c:pt>
                  <c:pt idx="3">
                    <c:v>3.5083894518028416E-2</c:v>
                  </c:pt>
                </c:numCache>
              </c:numRef>
            </c:minus>
          </c:errBars>
          <c:cat>
            <c:strRef>
              <c:f>Targ.summ!$BU$302:$BU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BX$302:$BX$305</c:f>
              <c:numCache>
                <c:formatCode>General</c:formatCode>
                <c:ptCount val="4"/>
                <c:pt idx="0">
                  <c:v>0.48792754027117352</c:v>
                </c:pt>
                <c:pt idx="1">
                  <c:v>0.15223611697153591</c:v>
                </c:pt>
                <c:pt idx="2">
                  <c:v>0.23428034065527101</c:v>
                </c:pt>
                <c:pt idx="3">
                  <c:v>0.24763447415749035</c:v>
                </c:pt>
              </c:numCache>
            </c:numRef>
          </c:val>
        </c:ser>
        <c:ser>
          <c:idx val="3"/>
          <c:order val="3"/>
          <c:tx>
            <c:strRef>
              <c:f>Targ.summ!$BY$301</c:f>
              <c:strCache>
                <c:ptCount val="1"/>
                <c:pt idx="0">
                  <c:v>28C-ihfB-isp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D$302:$CD$305</c:f>
                <c:numCache>
                  <c:formatCode>General</c:formatCode>
                  <c:ptCount val="4"/>
                  <c:pt idx="0">
                    <c:v>7.0448481204249111E-2</c:v>
                  </c:pt>
                  <c:pt idx="1">
                    <c:v>0.45190560363493232</c:v>
                  </c:pt>
                  <c:pt idx="2">
                    <c:v>0.132185913659885</c:v>
                  </c:pt>
                  <c:pt idx="3">
                    <c:v>0.40920731847457875</c:v>
                  </c:pt>
                </c:numCache>
              </c:numRef>
            </c:plus>
            <c:minus>
              <c:numRef>
                <c:f>Targ.summ!$CD$302:$CD$305</c:f>
                <c:numCache>
                  <c:formatCode>General</c:formatCode>
                  <c:ptCount val="4"/>
                  <c:pt idx="0">
                    <c:v>7.0448481204249111E-2</c:v>
                  </c:pt>
                  <c:pt idx="1">
                    <c:v>0.45190560363493232</c:v>
                  </c:pt>
                  <c:pt idx="2">
                    <c:v>0.132185913659885</c:v>
                  </c:pt>
                  <c:pt idx="3">
                    <c:v>0.40920731847457875</c:v>
                  </c:pt>
                </c:numCache>
              </c:numRef>
            </c:minus>
          </c:errBars>
          <c:cat>
            <c:strRef>
              <c:f>Targ.summ!$BU$302:$BU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BY$302:$BY$305</c:f>
              <c:numCache>
                <c:formatCode>General</c:formatCode>
                <c:ptCount val="4"/>
                <c:pt idx="0">
                  <c:v>1.3586187064744932</c:v>
                </c:pt>
                <c:pt idx="1">
                  <c:v>2.9437167338498269</c:v>
                </c:pt>
                <c:pt idx="2">
                  <c:v>1.3643786527110637</c:v>
                </c:pt>
                <c:pt idx="3">
                  <c:v>2.997015209195915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421312"/>
        <c:axId val="113435392"/>
      </c:barChart>
      <c:catAx>
        <c:axId val="113421312"/>
        <c:scaling>
          <c:orientation val="minMax"/>
        </c:scaling>
        <c:delete val="0"/>
        <c:axPos val="b"/>
        <c:majorTickMark val="out"/>
        <c:minorTickMark val="none"/>
        <c:tickLblPos val="low"/>
        <c:crossAx val="113435392"/>
        <c:crosses val="autoZero"/>
        <c:auto val="1"/>
        <c:lblAlgn val="ctr"/>
        <c:lblOffset val="100"/>
        <c:noMultiLvlLbl val="0"/>
      </c:catAx>
      <c:valAx>
        <c:axId val="113435392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</a:t>
                </a:r>
                <a:r>
                  <a:rPr lang="en-US" baseline="0"/>
                  <a:t> change (IPTG vs. Ctrl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low"/>
        <c:crossAx val="113421312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spH expression at 37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CG$251</c:f>
              <c:strCache>
                <c:ptCount val="1"/>
                <c:pt idx="0">
                  <c:v>37C-37C Top3-ispH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L$252:$CL$255</c:f>
                <c:numCache>
                  <c:formatCode>General</c:formatCode>
                  <c:ptCount val="4"/>
                  <c:pt idx="0">
                    <c:v>5.048517282158882E-2</c:v>
                  </c:pt>
                  <c:pt idx="1">
                    <c:v>0.11003107197868309</c:v>
                  </c:pt>
                  <c:pt idx="2">
                    <c:v>0.18994274959183238</c:v>
                  </c:pt>
                  <c:pt idx="3">
                    <c:v>0.25990986286836182</c:v>
                  </c:pt>
                </c:numCache>
              </c:numRef>
            </c:plus>
            <c:minus>
              <c:numRef>
                <c:f>Targ.summ!$CL$252:$CL$255</c:f>
                <c:numCache>
                  <c:formatCode>General</c:formatCode>
                  <c:ptCount val="4"/>
                  <c:pt idx="0">
                    <c:v>5.048517282158882E-2</c:v>
                  </c:pt>
                  <c:pt idx="1">
                    <c:v>0.11003107197868309</c:v>
                  </c:pt>
                  <c:pt idx="2">
                    <c:v>0.18994274959183238</c:v>
                  </c:pt>
                  <c:pt idx="3">
                    <c:v>0.25990986286836182</c:v>
                  </c:pt>
                </c:numCache>
              </c:numRef>
            </c:minus>
          </c:errBars>
          <c:cat>
            <c:strRef>
              <c:f>Targ.summ!$CF$252:$CF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CG$252:$CG$255</c:f>
              <c:numCache>
                <c:formatCode>General</c:formatCode>
                <c:ptCount val="4"/>
                <c:pt idx="0">
                  <c:v>0.60761301961775394</c:v>
                </c:pt>
                <c:pt idx="1">
                  <c:v>1.0893039642226647</c:v>
                </c:pt>
                <c:pt idx="2">
                  <c:v>1.9806778589116865</c:v>
                </c:pt>
                <c:pt idx="3">
                  <c:v>2.3464492200711438</c:v>
                </c:pt>
              </c:numCache>
            </c:numRef>
          </c:val>
        </c:ser>
        <c:ser>
          <c:idx val="1"/>
          <c:order val="1"/>
          <c:tx>
            <c:strRef>
              <c:f>Targ.summ!$CH$251</c:f>
              <c:strCache>
                <c:ptCount val="1"/>
                <c:pt idx="0">
                  <c:v>37C-Top3-ispH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M$252:$CM$255</c:f>
                <c:numCache>
                  <c:formatCode>General</c:formatCode>
                  <c:ptCount val="4"/>
                  <c:pt idx="0">
                    <c:v>5.048517282158882E-2</c:v>
                  </c:pt>
                  <c:pt idx="1">
                    <c:v>0.11003107197868273</c:v>
                  </c:pt>
                  <c:pt idx="2">
                    <c:v>0.18994274959183313</c:v>
                  </c:pt>
                  <c:pt idx="3">
                    <c:v>0.25990986286836382</c:v>
                  </c:pt>
                </c:numCache>
              </c:numRef>
            </c:plus>
            <c:minus>
              <c:numRef>
                <c:f>Targ.summ!$CM$252:$CM$255</c:f>
                <c:numCache>
                  <c:formatCode>General</c:formatCode>
                  <c:ptCount val="4"/>
                  <c:pt idx="0">
                    <c:v>5.048517282158882E-2</c:v>
                  </c:pt>
                  <c:pt idx="1">
                    <c:v>0.11003107197868273</c:v>
                  </c:pt>
                  <c:pt idx="2">
                    <c:v>0.18994274959183313</c:v>
                  </c:pt>
                  <c:pt idx="3">
                    <c:v>0.25990986286836382</c:v>
                  </c:pt>
                </c:numCache>
              </c:numRef>
            </c:minus>
          </c:errBars>
          <c:cat>
            <c:strRef>
              <c:f>Targ.summ!$CF$252:$CF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CH$252:$CH$255</c:f>
              <c:numCache>
                <c:formatCode>General</c:formatCode>
                <c:ptCount val="4"/>
                <c:pt idx="0">
                  <c:v>0.60761301961775394</c:v>
                </c:pt>
                <c:pt idx="1">
                  <c:v>1.0893039642226647</c:v>
                </c:pt>
                <c:pt idx="2">
                  <c:v>1.9806778589116869</c:v>
                </c:pt>
                <c:pt idx="3">
                  <c:v>2.3464492200711438</c:v>
                </c:pt>
              </c:numCache>
            </c:numRef>
          </c:val>
        </c:ser>
        <c:ser>
          <c:idx val="2"/>
          <c:order val="2"/>
          <c:tx>
            <c:strRef>
              <c:f>Targ.summ!$CI$251</c:f>
              <c:strCache>
                <c:ptCount val="1"/>
                <c:pt idx="0">
                  <c:v>37C-rrsA-ispH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N$252:$CN$255</c:f>
                <c:numCache>
                  <c:formatCode>General</c:formatCode>
                  <c:ptCount val="4"/>
                  <c:pt idx="0">
                    <c:v>4.7295978158480294E-2</c:v>
                  </c:pt>
                  <c:pt idx="1">
                    <c:v>6.6351484395110974E-2</c:v>
                  </c:pt>
                  <c:pt idx="2">
                    <c:v>0.15152879825405507</c:v>
                  </c:pt>
                  <c:pt idx="3">
                    <c:v>0.30435658995101728</c:v>
                  </c:pt>
                </c:numCache>
              </c:numRef>
            </c:plus>
            <c:minus>
              <c:numRef>
                <c:f>Targ.summ!$CN$252:$CN$255</c:f>
                <c:numCache>
                  <c:formatCode>General</c:formatCode>
                  <c:ptCount val="4"/>
                  <c:pt idx="0">
                    <c:v>4.7295978158480294E-2</c:v>
                  </c:pt>
                  <c:pt idx="1">
                    <c:v>6.6351484395110974E-2</c:v>
                  </c:pt>
                  <c:pt idx="2">
                    <c:v>0.15152879825405507</c:v>
                  </c:pt>
                  <c:pt idx="3">
                    <c:v>0.30435658995101728</c:v>
                  </c:pt>
                </c:numCache>
              </c:numRef>
            </c:minus>
          </c:errBars>
          <c:cat>
            <c:strRef>
              <c:f>Targ.summ!$CF$252:$CF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CI$252:$CI$255</c:f>
              <c:numCache>
                <c:formatCode>General</c:formatCode>
                <c:ptCount val="4"/>
                <c:pt idx="0">
                  <c:v>0.14782969179949093</c:v>
                </c:pt>
                <c:pt idx="1">
                  <c:v>0.32866731553315232</c:v>
                </c:pt>
                <c:pt idx="2">
                  <c:v>0.7120325682875055</c:v>
                </c:pt>
                <c:pt idx="3">
                  <c:v>1.1707983880251376</c:v>
                </c:pt>
              </c:numCache>
            </c:numRef>
          </c:val>
        </c:ser>
        <c:ser>
          <c:idx val="3"/>
          <c:order val="3"/>
          <c:tx>
            <c:strRef>
              <c:f>Targ.summ!$CJ$251</c:f>
              <c:strCache>
                <c:ptCount val="1"/>
                <c:pt idx="0">
                  <c:v>37C-ihfB-isp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O$252:$CO$255</c:f>
                <c:numCache>
                  <c:formatCode>General</c:formatCode>
                  <c:ptCount val="4"/>
                  <c:pt idx="0">
                    <c:v>0.59382870485150852</c:v>
                  </c:pt>
                  <c:pt idx="1">
                    <c:v>1.2816134295263388</c:v>
                  </c:pt>
                  <c:pt idx="2">
                    <c:v>0.8252399047504827</c:v>
                  </c:pt>
                  <c:pt idx="3">
                    <c:v>0.72562956246309873</c:v>
                  </c:pt>
                </c:numCache>
              </c:numRef>
            </c:plus>
            <c:minus>
              <c:numRef>
                <c:f>Targ.summ!$CO$252:$CO$255</c:f>
                <c:numCache>
                  <c:formatCode>General</c:formatCode>
                  <c:ptCount val="4"/>
                  <c:pt idx="0">
                    <c:v>0.59382870485150852</c:v>
                  </c:pt>
                  <c:pt idx="1">
                    <c:v>1.2816134295263388</c:v>
                  </c:pt>
                  <c:pt idx="2">
                    <c:v>0.8252399047504827</c:v>
                  </c:pt>
                  <c:pt idx="3">
                    <c:v>0.72562956246309873</c:v>
                  </c:pt>
                </c:numCache>
              </c:numRef>
            </c:minus>
          </c:errBars>
          <c:cat>
            <c:strRef>
              <c:f>Targ.summ!$CF$252:$CF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CJ$252:$CJ$255</c:f>
              <c:numCache>
                <c:formatCode>General</c:formatCode>
                <c:ptCount val="4"/>
                <c:pt idx="0">
                  <c:v>2.3014354505754677</c:v>
                </c:pt>
                <c:pt idx="1">
                  <c:v>5.2849768682118645</c:v>
                </c:pt>
                <c:pt idx="2">
                  <c:v>5.1626576390837817</c:v>
                </c:pt>
                <c:pt idx="3">
                  <c:v>3.86326994053607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495424"/>
        <c:axId val="113501312"/>
      </c:barChart>
      <c:catAx>
        <c:axId val="113495424"/>
        <c:scaling>
          <c:orientation val="minMax"/>
        </c:scaling>
        <c:delete val="0"/>
        <c:axPos val="b"/>
        <c:majorTickMark val="out"/>
        <c:minorTickMark val="none"/>
        <c:tickLblPos val="low"/>
        <c:crossAx val="113501312"/>
        <c:crosses val="autoZero"/>
        <c:auto val="1"/>
        <c:lblAlgn val="ctr"/>
        <c:lblOffset val="100"/>
        <c:noMultiLvlLbl val="0"/>
      </c:catAx>
      <c:valAx>
        <c:axId val="113501312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PTG vs. Ctr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3495424"/>
        <c:crosses val="autoZero"/>
        <c:crossBetween val="between"/>
        <c:majorUnit val="0.5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spH expression at 28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CG$301</c:f>
              <c:strCache>
                <c:ptCount val="1"/>
                <c:pt idx="0">
                  <c:v>28C-28C Top3-ispH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L$302:$CL$305</c:f>
                <c:numCache>
                  <c:formatCode>General</c:formatCode>
                  <c:ptCount val="4"/>
                  <c:pt idx="0">
                    <c:v>0.12254716825647166</c:v>
                  </c:pt>
                  <c:pt idx="1">
                    <c:v>2.1331531703462112E-2</c:v>
                  </c:pt>
                  <c:pt idx="2">
                    <c:v>8.7566735568503862E-2</c:v>
                  </c:pt>
                  <c:pt idx="3">
                    <c:v>0.13974701365434791</c:v>
                  </c:pt>
                </c:numCache>
              </c:numRef>
            </c:plus>
            <c:minus>
              <c:numRef>
                <c:f>Targ.summ!$CL$302:$CL$305</c:f>
                <c:numCache>
                  <c:formatCode>General</c:formatCode>
                  <c:ptCount val="4"/>
                  <c:pt idx="0">
                    <c:v>0.12254716825647166</c:v>
                  </c:pt>
                  <c:pt idx="1">
                    <c:v>2.1331531703462112E-2</c:v>
                  </c:pt>
                  <c:pt idx="2">
                    <c:v>8.7566735568503862E-2</c:v>
                  </c:pt>
                  <c:pt idx="3">
                    <c:v>0.13974701365434791</c:v>
                  </c:pt>
                </c:numCache>
              </c:numRef>
            </c:minus>
          </c:errBars>
          <c:cat>
            <c:strRef>
              <c:f>Targ.summ!$CF$302:$CF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CG$302:$CG$305</c:f>
              <c:numCache>
                <c:formatCode>General</c:formatCode>
                <c:ptCount val="4"/>
                <c:pt idx="0">
                  <c:v>0.97634044708385082</c:v>
                </c:pt>
                <c:pt idx="1">
                  <c:v>0.65089087027136239</c:v>
                </c:pt>
                <c:pt idx="2">
                  <c:v>0.88735746031657003</c:v>
                </c:pt>
                <c:pt idx="3">
                  <c:v>1.5774743439446606</c:v>
                </c:pt>
              </c:numCache>
            </c:numRef>
          </c:val>
        </c:ser>
        <c:ser>
          <c:idx val="1"/>
          <c:order val="1"/>
          <c:tx>
            <c:strRef>
              <c:f>Targ.summ!$CH$301</c:f>
              <c:strCache>
                <c:ptCount val="1"/>
                <c:pt idx="0">
                  <c:v>28C-Top3-ispH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M$302:$CM$305</c:f>
                <c:numCache>
                  <c:formatCode>General</c:formatCode>
                  <c:ptCount val="4"/>
                  <c:pt idx="0">
                    <c:v>0.13536435848530395</c:v>
                  </c:pt>
                  <c:pt idx="1">
                    <c:v>3.4281900657995086E-2</c:v>
                  </c:pt>
                  <c:pt idx="2">
                    <c:v>8.1246389703478583E-2</c:v>
                  </c:pt>
                  <c:pt idx="3">
                    <c:v>0.11410574826246379</c:v>
                  </c:pt>
                </c:numCache>
              </c:numRef>
            </c:plus>
            <c:minus>
              <c:numRef>
                <c:f>Targ.summ!$CM$302:$CM$305</c:f>
                <c:numCache>
                  <c:formatCode>General</c:formatCode>
                  <c:ptCount val="4"/>
                  <c:pt idx="0">
                    <c:v>0.13536435848530395</c:v>
                  </c:pt>
                  <c:pt idx="1">
                    <c:v>3.4281900657995086E-2</c:v>
                  </c:pt>
                  <c:pt idx="2">
                    <c:v>8.1246389703478583E-2</c:v>
                  </c:pt>
                  <c:pt idx="3">
                    <c:v>0.11410574826246379</c:v>
                  </c:pt>
                </c:numCache>
              </c:numRef>
            </c:minus>
          </c:errBars>
          <c:cat>
            <c:strRef>
              <c:f>Targ.summ!$CF$302:$CF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CH$302:$CH$305</c:f>
              <c:numCache>
                <c:formatCode>General</c:formatCode>
                <c:ptCount val="4"/>
                <c:pt idx="0">
                  <c:v>1.0664375397204073</c:v>
                </c:pt>
                <c:pt idx="1">
                  <c:v>0.6287315653743949</c:v>
                </c:pt>
                <c:pt idx="2">
                  <c:v>0.84742620789557532</c:v>
                </c:pt>
                <c:pt idx="3">
                  <c:v>1.6390504008452158</c:v>
                </c:pt>
              </c:numCache>
            </c:numRef>
          </c:val>
        </c:ser>
        <c:ser>
          <c:idx val="2"/>
          <c:order val="2"/>
          <c:tx>
            <c:strRef>
              <c:f>Targ.summ!$CI$301</c:f>
              <c:strCache>
                <c:ptCount val="1"/>
                <c:pt idx="0">
                  <c:v>28C-rrsA-ispH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N$302:$CN$305</c:f>
                <c:numCache>
                  <c:formatCode>General</c:formatCode>
                  <c:ptCount val="4"/>
                  <c:pt idx="0">
                    <c:v>8.8830254794351027E-2</c:v>
                  </c:pt>
                  <c:pt idx="1">
                    <c:v>1.7197919616769503E-2</c:v>
                  </c:pt>
                  <c:pt idx="2">
                    <c:v>3.6894587653313625E-2</c:v>
                  </c:pt>
                  <c:pt idx="3">
                    <c:v>8.0684868932201392E-2</c:v>
                  </c:pt>
                </c:numCache>
              </c:numRef>
            </c:plus>
            <c:minus>
              <c:numRef>
                <c:f>Targ.summ!$CN$302:$CN$305</c:f>
                <c:numCache>
                  <c:formatCode>General</c:formatCode>
                  <c:ptCount val="4"/>
                  <c:pt idx="0">
                    <c:v>8.8830254794351027E-2</c:v>
                  </c:pt>
                  <c:pt idx="1">
                    <c:v>1.7197919616769503E-2</c:v>
                  </c:pt>
                  <c:pt idx="2">
                    <c:v>3.6894587653313625E-2</c:v>
                  </c:pt>
                  <c:pt idx="3">
                    <c:v>8.0684868932201392E-2</c:v>
                  </c:pt>
                </c:numCache>
              </c:numRef>
            </c:minus>
          </c:errBars>
          <c:cat>
            <c:strRef>
              <c:f>Targ.summ!$CF$302:$CF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CI$302:$CI$305</c:f>
              <c:numCache>
                <c:formatCode>General</c:formatCode>
                <c:ptCount val="4"/>
                <c:pt idx="0">
                  <c:v>0.66481454064320666</c:v>
                </c:pt>
                <c:pt idx="1">
                  <c:v>0.11383147652132601</c:v>
                </c:pt>
                <c:pt idx="2">
                  <c:v>0.3265512448347293</c:v>
                </c:pt>
                <c:pt idx="3">
                  <c:v>0.50517613901749547</c:v>
                </c:pt>
              </c:numCache>
            </c:numRef>
          </c:val>
        </c:ser>
        <c:ser>
          <c:idx val="3"/>
          <c:order val="3"/>
          <c:tx>
            <c:strRef>
              <c:f>Targ.summ!$CJ$301</c:f>
              <c:strCache>
                <c:ptCount val="1"/>
                <c:pt idx="0">
                  <c:v>28C-ihfB-isp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O$302:$CO$305</c:f>
                <c:numCache>
                  <c:formatCode>General</c:formatCode>
                  <c:ptCount val="4"/>
                  <c:pt idx="0">
                    <c:v>0.12858395019967969</c:v>
                  </c:pt>
                  <c:pt idx="1">
                    <c:v>0.17236760678798344</c:v>
                  </c:pt>
                  <c:pt idx="2">
                    <c:v>0.12217083199627921</c:v>
                  </c:pt>
                  <c:pt idx="3">
                    <c:v>0.47701506008657935</c:v>
                  </c:pt>
                </c:numCache>
              </c:numRef>
            </c:plus>
            <c:minus>
              <c:numRef>
                <c:f>Targ.summ!$CO$302:$CO$305</c:f>
                <c:numCache>
                  <c:formatCode>General</c:formatCode>
                  <c:ptCount val="4"/>
                  <c:pt idx="0">
                    <c:v>0.12858395019967969</c:v>
                  </c:pt>
                  <c:pt idx="1">
                    <c:v>0.17236760678798344</c:v>
                  </c:pt>
                  <c:pt idx="2">
                    <c:v>0.12217083199627921</c:v>
                  </c:pt>
                  <c:pt idx="3">
                    <c:v>0.47701506008657935</c:v>
                  </c:pt>
                </c:numCache>
              </c:numRef>
            </c:minus>
          </c:errBars>
          <c:cat>
            <c:strRef>
              <c:f>Targ.summ!$CF$302:$CF$305</c:f>
              <c:strCache>
                <c:ptCount val="4"/>
                <c:pt idx="0">
                  <c:v>28C SIDF 0.01mM 4h</c:v>
                </c:pt>
                <c:pt idx="1">
                  <c:v>28C SIDF 0.1mM 4h</c:v>
                </c:pt>
                <c:pt idx="2">
                  <c:v>28C SIDF 0.01mM 8h</c:v>
                </c:pt>
                <c:pt idx="3">
                  <c:v>28C SIDF 0.1mM 8h</c:v>
                </c:pt>
              </c:strCache>
            </c:strRef>
          </c:cat>
          <c:val>
            <c:numRef>
              <c:f>Targ.summ!$CJ$302:$CJ$305</c:f>
              <c:numCache>
                <c:formatCode>General</c:formatCode>
                <c:ptCount val="4"/>
                <c:pt idx="0">
                  <c:v>1.8396921062818141</c:v>
                </c:pt>
                <c:pt idx="1">
                  <c:v>2.0950003197737033</c:v>
                </c:pt>
                <c:pt idx="2">
                  <c:v>1.906113889027869</c:v>
                </c:pt>
                <c:pt idx="3">
                  <c:v>5.6042195577401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616384"/>
        <c:axId val="113617920"/>
      </c:barChart>
      <c:catAx>
        <c:axId val="113616384"/>
        <c:scaling>
          <c:orientation val="minMax"/>
        </c:scaling>
        <c:delete val="0"/>
        <c:axPos val="b"/>
        <c:majorTickMark val="out"/>
        <c:minorTickMark val="none"/>
        <c:tickLblPos val="low"/>
        <c:crossAx val="113617920"/>
        <c:crosses val="autoZero"/>
        <c:auto val="1"/>
        <c:lblAlgn val="ctr"/>
        <c:lblOffset val="100"/>
        <c:noMultiLvlLbl val="0"/>
      </c:catAx>
      <c:valAx>
        <c:axId val="113617920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</a:t>
                </a:r>
                <a:r>
                  <a:rPr lang="en-US" baseline="0"/>
                  <a:t> change (IPTG vs. Ctrl)</a:t>
                </a:r>
                <a:endParaRPr lang="en-US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361638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/>
              <a:t>Normalized ispA expression at 37</a:t>
            </a:r>
            <a:r>
              <a:rPr lang="en-US" sz="1600" b="1" i="0" u="none" strike="noStrike" baseline="0"/>
              <a:t>°</a:t>
            </a:r>
            <a:r>
              <a:rPr lang="en-US" sz="1600"/>
              <a:t>C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rg.summ!$CR$251</c:f>
              <c:strCache>
                <c:ptCount val="1"/>
                <c:pt idx="0">
                  <c:v>37C-37C Top3-isp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W$252:$CW$255</c:f>
                <c:numCache>
                  <c:formatCode>General</c:formatCode>
                  <c:ptCount val="4"/>
                  <c:pt idx="0">
                    <c:v>0.20201642310557269</c:v>
                  </c:pt>
                  <c:pt idx="1">
                    <c:v>0.43512670768203676</c:v>
                  </c:pt>
                  <c:pt idx="2">
                    <c:v>0.19617926649198128</c:v>
                  </c:pt>
                  <c:pt idx="3">
                    <c:v>0.28836756125694496</c:v>
                  </c:pt>
                </c:numCache>
              </c:numRef>
            </c:plus>
            <c:minus>
              <c:numRef>
                <c:f>Targ.summ!$CW$252:$CW$255</c:f>
                <c:numCache>
                  <c:formatCode>General</c:formatCode>
                  <c:ptCount val="4"/>
                  <c:pt idx="0">
                    <c:v>0.20201642310557269</c:v>
                  </c:pt>
                  <c:pt idx="1">
                    <c:v>0.43512670768203676</c:v>
                  </c:pt>
                  <c:pt idx="2">
                    <c:v>0.19617926649198128</c:v>
                  </c:pt>
                  <c:pt idx="3">
                    <c:v>0.28836756125694496</c:v>
                  </c:pt>
                </c:numCache>
              </c:numRef>
            </c:minus>
          </c:errBars>
          <c:cat>
            <c:strRef>
              <c:f>Targ.summ!$CQ$252:$CQ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CR$252:$CR$255</c:f>
              <c:numCache>
                <c:formatCode>General</c:formatCode>
                <c:ptCount val="4"/>
                <c:pt idx="0">
                  <c:v>1.2136068705324345</c:v>
                </c:pt>
                <c:pt idx="1">
                  <c:v>1.8403828413352759</c:v>
                </c:pt>
                <c:pt idx="2">
                  <c:v>1.6530516484928677</c:v>
                </c:pt>
                <c:pt idx="3">
                  <c:v>1.5401555131126681</c:v>
                </c:pt>
              </c:numCache>
            </c:numRef>
          </c:val>
        </c:ser>
        <c:ser>
          <c:idx val="1"/>
          <c:order val="1"/>
          <c:tx>
            <c:strRef>
              <c:f>Targ.summ!$CS$251</c:f>
              <c:strCache>
                <c:ptCount val="1"/>
                <c:pt idx="0">
                  <c:v>37C-Top3-ispA</c:v>
                </c:pt>
              </c:strCache>
            </c:strRef>
          </c:tx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X$252:$CX$255</c:f>
                <c:numCache>
                  <c:formatCode>General</c:formatCode>
                  <c:ptCount val="4"/>
                  <c:pt idx="0">
                    <c:v>0.20201642310557269</c:v>
                  </c:pt>
                  <c:pt idx="1">
                    <c:v>0.43512670768203704</c:v>
                  </c:pt>
                  <c:pt idx="2">
                    <c:v>0.19617926649198036</c:v>
                  </c:pt>
                  <c:pt idx="3">
                    <c:v>0.28836756125694457</c:v>
                  </c:pt>
                </c:numCache>
              </c:numRef>
            </c:plus>
            <c:minus>
              <c:numRef>
                <c:f>Targ.summ!$CX$252:$CX$255</c:f>
                <c:numCache>
                  <c:formatCode>General</c:formatCode>
                  <c:ptCount val="4"/>
                  <c:pt idx="0">
                    <c:v>0.20201642310557269</c:v>
                  </c:pt>
                  <c:pt idx="1">
                    <c:v>0.43512670768203704</c:v>
                  </c:pt>
                  <c:pt idx="2">
                    <c:v>0.19617926649198036</c:v>
                  </c:pt>
                  <c:pt idx="3">
                    <c:v>0.28836756125694457</c:v>
                  </c:pt>
                </c:numCache>
              </c:numRef>
            </c:minus>
          </c:errBars>
          <c:cat>
            <c:strRef>
              <c:f>Targ.summ!$CQ$252:$CQ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CS$252:$CS$255</c:f>
              <c:numCache>
                <c:formatCode>General</c:formatCode>
                <c:ptCount val="4"/>
                <c:pt idx="0">
                  <c:v>1.2136068705324345</c:v>
                </c:pt>
                <c:pt idx="1">
                  <c:v>1.8403828413352754</c:v>
                </c:pt>
                <c:pt idx="2">
                  <c:v>1.6530516484928679</c:v>
                </c:pt>
                <c:pt idx="3">
                  <c:v>1.5401555131126681</c:v>
                </c:pt>
              </c:numCache>
            </c:numRef>
          </c:val>
        </c:ser>
        <c:ser>
          <c:idx val="2"/>
          <c:order val="2"/>
          <c:tx>
            <c:strRef>
              <c:f>Targ.summ!$CT$251</c:f>
              <c:strCache>
                <c:ptCount val="1"/>
                <c:pt idx="0">
                  <c:v>37C-rrsA-isp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Y$252:$CY$255</c:f>
                <c:numCache>
                  <c:formatCode>General</c:formatCode>
                  <c:ptCount val="4"/>
                  <c:pt idx="0">
                    <c:v>0.11105272801475595</c:v>
                  </c:pt>
                  <c:pt idx="1">
                    <c:v>0.16101646028685454</c:v>
                  </c:pt>
                  <c:pt idx="2">
                    <c:v>0.15299238613060537</c:v>
                  </c:pt>
                  <c:pt idx="3">
                    <c:v>0.30760236663705798</c:v>
                  </c:pt>
                </c:numCache>
              </c:numRef>
            </c:plus>
            <c:minus>
              <c:numRef>
                <c:f>Targ.summ!$CY$252:$CY$255</c:f>
                <c:numCache>
                  <c:formatCode>General</c:formatCode>
                  <c:ptCount val="4"/>
                  <c:pt idx="0">
                    <c:v>0.11105272801475595</c:v>
                  </c:pt>
                  <c:pt idx="1">
                    <c:v>0.16101646028685454</c:v>
                  </c:pt>
                  <c:pt idx="2">
                    <c:v>0.15299238613060537</c:v>
                  </c:pt>
                  <c:pt idx="3">
                    <c:v>0.30760236663705798</c:v>
                  </c:pt>
                </c:numCache>
              </c:numRef>
            </c:minus>
          </c:errBars>
          <c:cat>
            <c:strRef>
              <c:f>Targ.summ!$CQ$252:$CQ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CT$252:$CT$255</c:f>
              <c:numCache>
                <c:formatCode>General</c:formatCode>
                <c:ptCount val="4"/>
                <c:pt idx="0">
                  <c:v>0.28927945638308794</c:v>
                </c:pt>
                <c:pt idx="1">
                  <c:v>0.53137105055732381</c:v>
                </c:pt>
                <c:pt idx="2">
                  <c:v>0.59190288407969116</c:v>
                </c:pt>
                <c:pt idx="3">
                  <c:v>0.79473096292827794</c:v>
                </c:pt>
              </c:numCache>
            </c:numRef>
          </c:val>
        </c:ser>
        <c:ser>
          <c:idx val="3"/>
          <c:order val="3"/>
          <c:tx>
            <c:strRef>
              <c:f>Targ.summ!$CU$251</c:f>
              <c:strCache>
                <c:ptCount val="1"/>
                <c:pt idx="0">
                  <c:v>37C-ihfB-isp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Targ.summ!$CZ$252:$CZ$255</c:f>
                <c:numCache>
                  <c:formatCode>General</c:formatCode>
                  <c:ptCount val="4"/>
                  <c:pt idx="0">
                    <c:v>1.4775402555276045</c:v>
                  </c:pt>
                  <c:pt idx="1">
                    <c:v>3.7803610897707967</c:v>
                  </c:pt>
                  <c:pt idx="2">
                    <c:v>0.77366392009814788</c:v>
                  </c:pt>
                  <c:pt idx="3">
                    <c:v>0.67858682723784591</c:v>
                  </c:pt>
                </c:numCache>
              </c:numRef>
            </c:plus>
            <c:minus>
              <c:numRef>
                <c:f>Targ.summ!$CZ$252:$CZ$255</c:f>
                <c:numCache>
                  <c:formatCode>General</c:formatCode>
                  <c:ptCount val="4"/>
                  <c:pt idx="0">
                    <c:v>1.4775402555276045</c:v>
                  </c:pt>
                  <c:pt idx="1">
                    <c:v>3.7803610897707967</c:v>
                  </c:pt>
                  <c:pt idx="2">
                    <c:v>0.77366392009814788</c:v>
                  </c:pt>
                  <c:pt idx="3">
                    <c:v>0.67858682723784591</c:v>
                  </c:pt>
                </c:numCache>
              </c:numRef>
            </c:minus>
          </c:errBars>
          <c:cat>
            <c:strRef>
              <c:f>Targ.summ!$CQ$252:$CQ$255</c:f>
              <c:strCache>
                <c:ptCount val="4"/>
                <c:pt idx="0">
                  <c:v>37C SIDF 0.01mM 4h</c:v>
                </c:pt>
                <c:pt idx="1">
                  <c:v>37C SIDF 0.1mM 4h</c:v>
                </c:pt>
                <c:pt idx="2">
                  <c:v>37C SIDF 0.01mM 8h</c:v>
                </c:pt>
                <c:pt idx="3">
                  <c:v>37C SIDF 0.1mM 8h</c:v>
                </c:pt>
              </c:strCache>
            </c:strRef>
          </c:cat>
          <c:val>
            <c:numRef>
              <c:f>Targ.summ!$CU$252:$CU$255</c:f>
              <c:numCache>
                <c:formatCode>General</c:formatCode>
                <c:ptCount val="4"/>
                <c:pt idx="0">
                  <c:v>4.6541900329758858</c:v>
                </c:pt>
                <c:pt idx="1">
                  <c:v>9.6135812369966747</c:v>
                </c:pt>
                <c:pt idx="2">
                  <c:v>4.2004708065053435</c:v>
                </c:pt>
                <c:pt idx="3">
                  <c:v>2.50757958482731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642880"/>
        <c:axId val="113656960"/>
      </c:barChart>
      <c:catAx>
        <c:axId val="113642880"/>
        <c:scaling>
          <c:orientation val="minMax"/>
        </c:scaling>
        <c:delete val="0"/>
        <c:axPos val="b"/>
        <c:majorTickMark val="out"/>
        <c:minorTickMark val="none"/>
        <c:tickLblPos val="low"/>
        <c:crossAx val="113656960"/>
        <c:crosses val="autoZero"/>
        <c:auto val="1"/>
        <c:lblAlgn val="ctr"/>
        <c:lblOffset val="100"/>
        <c:noMultiLvlLbl val="0"/>
      </c:catAx>
      <c:valAx>
        <c:axId val="113656960"/>
        <c:scaling>
          <c:logBase val="2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Fold change (IPTG vs. Ctrl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3642880"/>
        <c:crosses val="autoZero"/>
        <c:crossBetween val="between"/>
        <c:majorUnit val="0.5"/>
      </c:valAx>
    </c:plotArea>
    <c:legend>
      <c:legendPos val="r"/>
      <c:layout/>
      <c:overlay val="0"/>
    </c:legend>
    <c:plotVisOnly val="1"/>
    <c:dispBlanksAs val="gap"/>
    <c:showDLblsOverMax val="0"/>
  </c:chart>
  <c:spPr>
    <a:ln>
      <a:solidFill>
        <a:schemeClr val="tx1">
          <a:lumMod val="50000"/>
          <a:lumOff val="50000"/>
        </a:schemeClr>
      </a:solidFill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3446BA74-3347-4E8D-B251-9BF2C2999201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A02E1ACD-3840-4B18-A204-B72641A2024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586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90478">
              <a:defRPr/>
            </a:pPr>
            <a:r>
              <a:rPr lang="en-US" sz="1300" b="1" dirty="0"/>
              <a:t>Supplementary </a:t>
            </a:r>
            <a:r>
              <a:rPr lang="en-US" sz="1300" b="1" dirty="0" smtClean="0"/>
              <a:t>table</a:t>
            </a:r>
            <a:r>
              <a:rPr lang="en-US" sz="1300" b="1" baseline="0" dirty="0" smtClean="0"/>
              <a:t> </a:t>
            </a:r>
            <a:r>
              <a:rPr lang="en-US" sz="1300" b="1" baseline="0" dirty="0" smtClean="0"/>
              <a:t>S</a:t>
            </a:r>
            <a:r>
              <a:rPr lang="en-US" sz="1300" b="1" dirty="0" smtClean="0"/>
              <a:t>1  </a:t>
            </a:r>
            <a:r>
              <a:rPr lang="en-US" sz="1300" b="1" dirty="0"/>
              <a:t>RT-qPCR assay design and performance. </a:t>
            </a:r>
            <a:r>
              <a:rPr lang="en-US" sz="1300" dirty="0"/>
              <a:t>Efficiencies of amplification and inter/intra-assay precisions of the assays used to measure the </a:t>
            </a:r>
            <a:r>
              <a:rPr lang="en-US" sz="1300" dirty="0" smtClean="0"/>
              <a:t>twenty </a:t>
            </a:r>
            <a:r>
              <a:rPr lang="en-US" sz="1300" dirty="0"/>
              <a:t>candidate reference genes, two commonly used housekeeping genes and seven target genes quantified in this study.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90478">
              <a:defRPr/>
            </a:pPr>
            <a:r>
              <a:rPr lang="en-US" sz="1300" b="1" dirty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sz="1300" b="1" smtClean="0">
                <a:latin typeface="Arial" pitchFamily="34" charset="0"/>
                <a:cs typeface="Arial" pitchFamily="34" charset="0"/>
              </a:rPr>
              <a:t>figure</a:t>
            </a:r>
            <a:r>
              <a:rPr lang="en-US" sz="1300" b="1" baseline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300" b="1" baseline="0" smtClean="0">
                <a:latin typeface="Arial" pitchFamily="34" charset="0"/>
                <a:cs typeface="Arial" pitchFamily="34" charset="0"/>
              </a:rPr>
              <a:t>S</a:t>
            </a:r>
            <a:r>
              <a:rPr lang="en-US" sz="1300" b="1" smtClean="0">
                <a:latin typeface="Arial" pitchFamily="34" charset="0"/>
                <a:cs typeface="Arial" pitchFamily="34" charset="0"/>
              </a:rPr>
              <a:t>6 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Fold change in rrsA (A), ihfB (B), and dxs (C) expression normalized to </a:t>
            </a:r>
            <a:r>
              <a:rPr lang="en-US" sz="1300" b="1" dirty="0" err="1">
                <a:latin typeface="Arial" pitchFamily="34" charset="0"/>
                <a:cs typeface="Arial" pitchFamily="34" charset="0"/>
              </a:rPr>
              <a:t>cysG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/</a:t>
            </a:r>
            <a:r>
              <a:rPr lang="en-US" sz="1300" b="1" dirty="0" err="1">
                <a:latin typeface="Arial" pitchFamily="34" charset="0"/>
                <a:cs typeface="Arial" pitchFamily="34" charset="0"/>
              </a:rPr>
              <a:t>hcaT</a:t>
            </a:r>
            <a:r>
              <a:rPr lang="en-US" sz="1300" b="1" dirty="0">
                <a:latin typeface="Arial" pitchFamily="34" charset="0"/>
                <a:cs typeface="Arial" pitchFamily="34" charset="0"/>
              </a:rPr>
              <a:t>/</a:t>
            </a:r>
            <a:r>
              <a:rPr lang="en-US" sz="1300" b="1" dirty="0" err="1">
                <a:latin typeface="Arial" pitchFamily="34" charset="0"/>
                <a:cs typeface="Arial" pitchFamily="34" charset="0"/>
              </a:rPr>
              <a:t>idnT</a:t>
            </a:r>
            <a:endParaRPr lang="en-US" sz="1300" b="1" dirty="0">
              <a:latin typeface="Arial" pitchFamily="34" charset="0"/>
              <a:cs typeface="Arial" pitchFamily="34" charset="0"/>
            </a:endParaRPr>
          </a:p>
          <a:p>
            <a:pPr defTabSz="990478">
              <a:defRPr/>
            </a:pPr>
            <a:r>
              <a:rPr lang="en-US" sz="1300" dirty="0">
                <a:latin typeface="Arial" pitchFamily="34" charset="0"/>
                <a:cs typeface="Arial" pitchFamily="34" charset="0"/>
              </a:rPr>
              <a:t>Fold changes in transcript expressions of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rrsA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(A) and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ihfB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(B) in IPTG induced cells relative to that of control were normalized by geometric mean of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idnT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cysG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, and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hcaT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. Fold changes in transcript expressions of dxs (C) at 0.5h, 2h, and 4h after induction relative to that at 0h after induction normalized by geometric mean of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idnT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cysG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, and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hcaT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.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10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90478">
              <a:defRPr/>
            </a:pPr>
            <a:r>
              <a:rPr lang="en-US" sz="1300" b="1" dirty="0"/>
              <a:t>Supplementary </a:t>
            </a:r>
            <a:r>
              <a:rPr lang="en-US" sz="1300" b="1" dirty="0" smtClean="0"/>
              <a:t>table</a:t>
            </a:r>
            <a:r>
              <a:rPr lang="en-US" sz="1300" b="1" baseline="0" dirty="0" smtClean="0"/>
              <a:t> </a:t>
            </a:r>
            <a:r>
              <a:rPr lang="en-US" sz="1300" b="1" baseline="0" dirty="0" smtClean="0"/>
              <a:t>S</a:t>
            </a:r>
            <a:r>
              <a:rPr lang="en-US" sz="1300" b="1" dirty="0" smtClean="0"/>
              <a:t>2 </a:t>
            </a:r>
            <a:r>
              <a:rPr lang="en-US" sz="1300" b="1" dirty="0"/>
              <a:t>Stability analysis of nineteen candidate reference genes in subgroups</a:t>
            </a:r>
          </a:p>
          <a:p>
            <a:pPr defTabSz="990478">
              <a:defRPr/>
            </a:pPr>
            <a:r>
              <a:rPr lang="en-US" sz="1300" dirty="0"/>
              <a:t>Stability rankings were determined by </a:t>
            </a:r>
            <a:r>
              <a:rPr lang="en-US" sz="1300" dirty="0" err="1"/>
              <a:t>geNorm</a:t>
            </a:r>
            <a:r>
              <a:rPr lang="en-US" sz="1300" dirty="0"/>
              <a:t> and </a:t>
            </a:r>
            <a:r>
              <a:rPr lang="en-US" sz="1300" i="1" dirty="0" err="1"/>
              <a:t>NormFinder</a:t>
            </a:r>
            <a:r>
              <a:rPr lang="en-US" sz="1300" i="1" dirty="0"/>
              <a:t> (Italic) </a:t>
            </a:r>
            <a:r>
              <a:rPr lang="en-US" sz="1300" dirty="0"/>
              <a:t>in each sample subgroups. The top three candidate genes (ldnT, </a:t>
            </a:r>
            <a:r>
              <a:rPr lang="en-US" sz="1300" dirty="0" err="1"/>
              <a:t>cysG</a:t>
            </a:r>
            <a:r>
              <a:rPr lang="en-US" sz="1300" dirty="0"/>
              <a:t> and </a:t>
            </a:r>
            <a:r>
              <a:rPr lang="en-US" sz="1300" dirty="0" err="1"/>
              <a:t>hcaT</a:t>
            </a:r>
            <a:r>
              <a:rPr lang="en-US" sz="1300" dirty="0"/>
              <a:t>)  in overall ranking (Figure 4) </a:t>
            </a:r>
            <a:r>
              <a:rPr lang="en-US" sz="1300" dirty="0" smtClean="0"/>
              <a:t>and the two HKGs were bolded and underlined.</a:t>
            </a:r>
            <a:endParaRPr lang="en-US" sz="130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sz="1300" b="1" dirty="0"/>
              <a:t>Supplementary </a:t>
            </a:r>
            <a:r>
              <a:rPr lang="en-US" sz="1300" b="1" dirty="0" smtClean="0"/>
              <a:t>table</a:t>
            </a:r>
            <a:r>
              <a:rPr lang="en-US" sz="1300" b="1" baseline="0" dirty="0" smtClean="0"/>
              <a:t> </a:t>
            </a:r>
            <a:r>
              <a:rPr lang="en-US" sz="1300" b="1" baseline="0" dirty="0" smtClean="0"/>
              <a:t>S</a:t>
            </a:r>
            <a:r>
              <a:rPr lang="en-US" sz="1300" b="1" dirty="0" smtClean="0"/>
              <a:t>3 </a:t>
            </a:r>
            <a:r>
              <a:rPr lang="en-US" sz="1300" b="1" dirty="0"/>
              <a:t>Stability analysis of fifteen candidate reference genes plus two commonly used house keeping genes in </a:t>
            </a:r>
            <a:r>
              <a:rPr lang="en-US" sz="1300" b="1" i="1" dirty="0"/>
              <a:t>E. Coli </a:t>
            </a:r>
            <a:r>
              <a:rPr lang="en-US" sz="1300" b="1" dirty="0"/>
              <a:t>DH10B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Stability rankings of the fifteen candidate reference genes and two house keeping genes, among all 15 biological samples, by </a:t>
            </a:r>
            <a:r>
              <a:rPr lang="en-US" sz="1300" dirty="0" err="1">
                <a:latin typeface="Arial" pitchFamily="34" charset="0"/>
                <a:ea typeface="Times New Roman" pitchFamily="18" charset="0"/>
                <a:cs typeface="Arial" pitchFamily="34" charset="0"/>
              </a:rPr>
              <a:t>geNorm</a:t>
            </a: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lang="en-US" sz="1300" b="1" dirty="0">
                <a:latin typeface="Arial" pitchFamily="34" charset="0"/>
                <a:ea typeface="Times New Roman" pitchFamily="18" charset="0"/>
                <a:cs typeface="Arial" pitchFamily="34" charset="0"/>
              </a:rPr>
              <a:t>(A)</a:t>
            </a: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lang="en-US" sz="1300" dirty="0" err="1">
                <a:latin typeface="Arial" pitchFamily="34" charset="0"/>
                <a:ea typeface="Times New Roman" pitchFamily="18" charset="0"/>
                <a:cs typeface="Arial" pitchFamily="34" charset="0"/>
              </a:rPr>
              <a:t>andNormFinder</a:t>
            </a: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lang="en-US" sz="1300" b="1" dirty="0">
                <a:latin typeface="Arial" pitchFamily="34" charset="0"/>
                <a:ea typeface="Times New Roman" pitchFamily="18" charset="0"/>
                <a:cs typeface="Arial" pitchFamily="34" charset="0"/>
              </a:rPr>
              <a:t>(B)</a:t>
            </a: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. A lower ‘Stability Value’ or ‘M-value’ correlates to higher gene expression stability. </a:t>
            </a:r>
            <a:endParaRPr lang="en-US" sz="1900" dirty="0">
              <a:latin typeface="Arial" pitchFamily="34" charset="0"/>
              <a:cs typeface="Arial" pitchFamily="34" charset="0"/>
            </a:endParaRPr>
          </a:p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 smtClean="0"/>
              <a:t>Supplementary</a:t>
            </a:r>
            <a:r>
              <a:rPr lang="en-US" b="1" baseline="0" dirty="0" smtClean="0"/>
              <a:t> figure </a:t>
            </a:r>
            <a:r>
              <a:rPr lang="en-US" b="1" baseline="0" dirty="0" smtClean="0"/>
              <a:t>S1 </a:t>
            </a:r>
            <a:r>
              <a:rPr lang="en-US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SDS-PAGE analysis of </a:t>
            </a:r>
            <a:r>
              <a:rPr lang="en-US" b="1" i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E. Coli </a:t>
            </a:r>
            <a:r>
              <a:rPr lang="en-US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BL21 harboring p20T7MEP on various conditions</a:t>
            </a:r>
          </a:p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Lane 1: 37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4h after induction, 0mM IPTG. Lane 2: 37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4h after induction, 0.01mM IPTG. Lane 3: 37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4h after induction, 0.1mM IPTG. Lane 4: 28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4h after induction, 0mM IPTG. Lane 5: 28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4h after induction, 0.01mM IPTG. Lane 6: 28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4h after induction, 0.1mM IPTG. Lane 7: 37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8h after induction, 0mM IPTG. Lane 8: 37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8h after induction, 0.01mM IPTG. Lane 9: 37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8h after induction, 0.1mM IPTG. Lane 10: 28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8h after induction, 0mM IPTG. Lane 11: 28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8h after induction, 0.01mM IPTG. Lane 12: 28</a:t>
            </a:r>
            <a:r>
              <a:rPr lang="en-US" sz="1200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°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, 8h after induction, 0.1mM IPTG. The arrow on the left indicates the expected size (65kDa) for dxs. All the cells harbor p20T7MEP and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pA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LYC. </a:t>
            </a:r>
            <a:endParaRPr lang="en-US" b="1" dirty="0" smtClean="0">
              <a:latin typeface="Arial" pitchFamily="34" charset="0"/>
              <a:cs typeface="Arial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93329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90478">
              <a:defRPr/>
            </a:pPr>
            <a:r>
              <a:rPr lang="en-GB" b="1" dirty="0">
                <a:latin typeface="Arial" pitchFamily="34" charset="0"/>
                <a:cs typeface="Arial" pitchFamily="34" charset="0"/>
              </a:rPr>
              <a:t>Supplementary </a:t>
            </a:r>
            <a:r>
              <a:rPr lang="en-GB" b="1" dirty="0" smtClean="0">
                <a:latin typeface="Arial" pitchFamily="34" charset="0"/>
                <a:cs typeface="Arial" pitchFamily="34" charset="0"/>
              </a:rPr>
              <a:t>figure</a:t>
            </a:r>
            <a:r>
              <a:rPr lang="en-GB" b="1" baseline="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b="1" baseline="0" dirty="0" smtClean="0">
                <a:latin typeface="Arial" pitchFamily="34" charset="0"/>
                <a:cs typeface="Arial" pitchFamily="34" charset="0"/>
              </a:rPr>
              <a:t>S</a:t>
            </a:r>
            <a:r>
              <a:rPr lang="en-GB" b="1" dirty="0" smtClean="0">
                <a:latin typeface="Arial" pitchFamily="34" charset="0"/>
                <a:cs typeface="Arial" pitchFamily="34" charset="0"/>
              </a:rPr>
              <a:t>2  </a:t>
            </a:r>
            <a:r>
              <a:rPr lang="en-GB" b="1" dirty="0">
                <a:latin typeface="Arial" pitchFamily="34" charset="0"/>
                <a:cs typeface="Arial" pitchFamily="34" charset="0"/>
              </a:rPr>
              <a:t>Distribution of the expression levels of genes examined in sample subgroups in </a:t>
            </a:r>
            <a:r>
              <a:rPr lang="en-GB" b="1" i="1" dirty="0">
                <a:latin typeface="Arial" pitchFamily="34" charset="0"/>
                <a:cs typeface="Arial" pitchFamily="34" charset="0"/>
              </a:rPr>
              <a:t>E. coli </a:t>
            </a:r>
            <a:r>
              <a:rPr lang="en-GB" b="1" dirty="0">
                <a:latin typeface="Arial" pitchFamily="34" charset="0"/>
                <a:cs typeface="Arial" pitchFamily="34" charset="0"/>
              </a:rPr>
              <a:t>Bl21 (DE3).  </a:t>
            </a:r>
          </a:p>
          <a:p>
            <a:pPr defTabSz="990478">
              <a:defRPr/>
            </a:pP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Box plot representation of the expression levels of </a:t>
            </a:r>
            <a:r>
              <a:rPr lang="en-US" sz="13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seventeen candidate </a:t>
            </a: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reference genes and two commonly used house-keeping genes in subgroups. The expression level of each gene was represented as the absolute copy number per unit input total RNA (0.0625µg), quantified by RT-qPCR using serial dilutions of standards. </a:t>
            </a:r>
            <a:endParaRPr lang="en-US" sz="1300" dirty="0">
              <a:latin typeface="Arial" pitchFamily="34" charset="0"/>
              <a:cs typeface="Arial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5</a:t>
            </a:fld>
            <a:endParaRPr 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90478" fontAlgn="base">
              <a:spcBef>
                <a:spcPct val="0"/>
              </a:spcBef>
              <a:spcAft>
                <a:spcPct val="0"/>
              </a:spcAft>
            </a:pPr>
            <a:r>
              <a:rPr lang="en-US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Supplementary figure</a:t>
            </a:r>
            <a:r>
              <a:rPr lang="en-US" b="1" baseline="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lang="en-US" b="1" baseline="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S</a:t>
            </a:r>
            <a:r>
              <a:rPr lang="en-US" b="1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3 </a:t>
            </a:r>
            <a:r>
              <a:rPr lang="en-US" b="1" dirty="0">
                <a:latin typeface="Arial" pitchFamily="34" charset="0"/>
                <a:ea typeface="Times New Roman" pitchFamily="18" charset="0"/>
                <a:cs typeface="Arial" pitchFamily="34" charset="0"/>
              </a:rPr>
              <a:t>Stability analysis of candidate reference genes and housekeeping genes in </a:t>
            </a:r>
            <a:r>
              <a:rPr lang="en-US" b="1" i="1" dirty="0">
                <a:latin typeface="Arial" pitchFamily="34" charset="0"/>
                <a:ea typeface="Times New Roman" pitchFamily="18" charset="0"/>
                <a:cs typeface="Arial" pitchFamily="34" charset="0"/>
              </a:rPr>
              <a:t>E. Coli </a:t>
            </a:r>
            <a:r>
              <a:rPr lang="en-US" b="1" dirty="0">
                <a:latin typeface="Arial" pitchFamily="34" charset="0"/>
                <a:ea typeface="Times New Roman" pitchFamily="18" charset="0"/>
                <a:cs typeface="Arial" pitchFamily="34" charset="0"/>
              </a:rPr>
              <a:t>BL21 (DE3). </a:t>
            </a:r>
            <a:endParaRPr lang="en-GB" sz="800" dirty="0">
              <a:latin typeface="Arial" pitchFamily="34" charset="0"/>
              <a:cs typeface="Arial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Stability rankings of </a:t>
            </a:r>
            <a:r>
              <a:rPr lang="en-US" sz="1300" dirty="0" smtClean="0">
                <a:latin typeface="Arial" pitchFamily="34" charset="0"/>
                <a:ea typeface="Times New Roman" pitchFamily="18" charset="0"/>
                <a:cs typeface="Arial" pitchFamily="34" charset="0"/>
              </a:rPr>
              <a:t>the </a:t>
            </a: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candidate reference genes, among all 72 biological samples, by geNorm </a:t>
            </a:r>
            <a:r>
              <a:rPr lang="en-US" sz="1300" b="1" dirty="0">
                <a:latin typeface="Arial" pitchFamily="34" charset="0"/>
                <a:ea typeface="Times New Roman" pitchFamily="18" charset="0"/>
                <a:cs typeface="Arial" pitchFamily="34" charset="0"/>
              </a:rPr>
              <a:t>(A)</a:t>
            </a: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 and NormFinder </a:t>
            </a:r>
            <a:r>
              <a:rPr lang="en-US" sz="1300" b="1" dirty="0">
                <a:latin typeface="Arial" pitchFamily="34" charset="0"/>
                <a:ea typeface="Times New Roman" pitchFamily="18" charset="0"/>
                <a:cs typeface="Arial" pitchFamily="34" charset="0"/>
              </a:rPr>
              <a:t>(B)</a:t>
            </a:r>
            <a:r>
              <a:rPr lang="en-US" sz="1300" dirty="0">
                <a:latin typeface="Arial" pitchFamily="34" charset="0"/>
                <a:ea typeface="Times New Roman" pitchFamily="18" charset="0"/>
                <a:cs typeface="Arial" pitchFamily="34" charset="0"/>
              </a:rPr>
              <a:t>. A lower ‘Stability Value’ or ‘M-value’ correlates to higher gene expression stability. </a:t>
            </a:r>
            <a:endParaRPr lang="en-US" sz="1900" dirty="0">
              <a:latin typeface="Arial" pitchFamily="34" charset="0"/>
              <a:cs typeface="Arial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6</a:t>
            </a:fld>
            <a:endParaRPr 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figure</a:t>
            </a:r>
            <a:r>
              <a:rPr lang="en-US" b="1" baseline="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b="1" baseline="0" dirty="0" smtClean="0">
                <a:latin typeface="Arial" pitchFamily="34" charset="0"/>
                <a:cs typeface="Arial" pitchFamily="34" charset="0"/>
              </a:rPr>
              <a:t>S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4 </a:t>
            </a:r>
            <a:r>
              <a:rPr lang="en-US" b="1" dirty="0">
                <a:latin typeface="Arial" pitchFamily="34" charset="0"/>
                <a:cs typeface="Arial" pitchFamily="34" charset="0"/>
              </a:rPr>
              <a:t>Fold changes in target gene expressions normalized using different reference gene(s) </a:t>
            </a:r>
            <a:r>
              <a:rPr lang="en-GB" b="1" dirty="0">
                <a:latin typeface="Arial" pitchFamily="34" charset="0"/>
                <a:cs typeface="Arial" pitchFamily="34" charset="0"/>
              </a:rPr>
              <a:t>in </a:t>
            </a:r>
            <a:r>
              <a:rPr lang="en-GB" b="1" i="1" dirty="0">
                <a:latin typeface="Arial" pitchFamily="34" charset="0"/>
                <a:cs typeface="Arial" pitchFamily="34" charset="0"/>
              </a:rPr>
              <a:t>E. coli </a:t>
            </a:r>
            <a:r>
              <a:rPr lang="en-GB" b="1" dirty="0">
                <a:latin typeface="Arial" pitchFamily="34" charset="0"/>
                <a:cs typeface="Arial" pitchFamily="34" charset="0"/>
              </a:rPr>
              <a:t>Bl21 (DE3). </a:t>
            </a:r>
            <a:endParaRPr lang="en-US" b="1" dirty="0">
              <a:latin typeface="Arial" pitchFamily="34" charset="0"/>
              <a:cs typeface="Arial" pitchFamily="34" charset="0"/>
            </a:endParaRPr>
          </a:p>
          <a:p>
            <a:r>
              <a:rPr lang="en-US" sz="1300" dirty="0">
                <a:latin typeface="Arial" pitchFamily="34" charset="0"/>
                <a:cs typeface="Arial" pitchFamily="34" charset="0"/>
              </a:rPr>
              <a:t>Fold changes in transcript expressions of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ispE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(A),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ispG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(B), ispH (C) and ispA (D) in IPTG induced cells relative to  that of control were normalized by (1) geometric mean of top three most stable genes in the temperature subgroup; (2) geometric mean of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idnT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cysG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, and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hcaT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; (3)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rrsA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or (4)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ihfB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. Normalization by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rrsA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falsely identified the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downregulation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of all target genes, and normalization by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ihfB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falsely identified the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upregulation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of all target genes. 2 is the threshold for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upregulation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 and 0.5 is the threshold for </a:t>
            </a:r>
            <a:r>
              <a:rPr lang="en-US" sz="1300" dirty="0" err="1">
                <a:latin typeface="Arial" pitchFamily="34" charset="0"/>
                <a:cs typeface="Arial" pitchFamily="34" charset="0"/>
              </a:rPr>
              <a:t>downregulation</a:t>
            </a:r>
            <a:r>
              <a:rPr lang="en-US" sz="1300" dirty="0">
                <a:latin typeface="Arial" pitchFamily="34" charset="0"/>
                <a:cs typeface="Arial" pitchFamily="34" charset="0"/>
              </a:rPr>
              <a:t>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7</a:t>
            </a:fld>
            <a:endParaRPr 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defTabSz="990478">
              <a:defRPr/>
            </a:pPr>
            <a:r>
              <a:rPr lang="en-US" sz="1100" b="1" dirty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figure</a:t>
            </a:r>
            <a:r>
              <a:rPr lang="en-US" sz="1100" b="1" baseline="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b="1" baseline="0" dirty="0" smtClean="0">
                <a:latin typeface="Arial" pitchFamily="34" charset="0"/>
                <a:cs typeface="Arial" pitchFamily="34" charset="0"/>
              </a:rPr>
              <a:t>S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4 </a:t>
            </a:r>
            <a:r>
              <a:rPr lang="en-US" sz="1100" b="1" dirty="0">
                <a:latin typeface="Arial" pitchFamily="34" charset="0"/>
                <a:cs typeface="Arial" pitchFamily="34" charset="0"/>
              </a:rPr>
              <a:t>Fold changes in target gene expressions normalized using different reference gene(s) </a:t>
            </a:r>
            <a:r>
              <a:rPr lang="en-GB" sz="1100" b="1" dirty="0">
                <a:latin typeface="Arial" pitchFamily="34" charset="0"/>
                <a:cs typeface="Arial" pitchFamily="34" charset="0"/>
              </a:rPr>
              <a:t>in </a:t>
            </a:r>
            <a:r>
              <a:rPr lang="en-GB" sz="1100" b="1" i="1" dirty="0">
                <a:latin typeface="Arial" pitchFamily="34" charset="0"/>
                <a:cs typeface="Arial" pitchFamily="34" charset="0"/>
              </a:rPr>
              <a:t>E. coli </a:t>
            </a:r>
            <a:r>
              <a:rPr lang="en-GB" sz="1100" b="1" dirty="0">
                <a:latin typeface="Arial" pitchFamily="34" charset="0"/>
                <a:cs typeface="Arial" pitchFamily="34" charset="0"/>
              </a:rPr>
              <a:t>Bl21 (DE3). 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  <a:p>
            <a:r>
              <a:rPr lang="en-US" dirty="0">
                <a:latin typeface="Arial" pitchFamily="34" charset="0"/>
                <a:cs typeface="Arial" pitchFamily="34" charset="0"/>
              </a:rPr>
              <a:t>Fold changes in transcript expressions of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ispE</a:t>
            </a:r>
            <a:r>
              <a:rPr lang="en-US" dirty="0">
                <a:latin typeface="Arial" pitchFamily="34" charset="0"/>
                <a:cs typeface="Arial" pitchFamily="34" charset="0"/>
              </a:rPr>
              <a:t> (A),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ispG</a:t>
            </a:r>
            <a:r>
              <a:rPr lang="en-US" dirty="0">
                <a:latin typeface="Arial" pitchFamily="34" charset="0"/>
                <a:cs typeface="Arial" pitchFamily="34" charset="0"/>
              </a:rPr>
              <a:t> (B), ispH (C) and ispA (D) in IPTG induced cells relative to  that of control were normalized by (1) geometric mean of top three most stable genes in the temperature subgroup; (2) geometric mean of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idnT</a:t>
            </a:r>
            <a:r>
              <a:rPr lang="en-US" dirty="0">
                <a:latin typeface="Arial" pitchFamily="34" charset="0"/>
                <a:cs typeface="Arial" pitchFamily="34" charset="0"/>
              </a:rPr>
              <a:t>,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cysG</a:t>
            </a:r>
            <a:r>
              <a:rPr lang="en-US" dirty="0">
                <a:latin typeface="Arial" pitchFamily="34" charset="0"/>
                <a:cs typeface="Arial" pitchFamily="34" charset="0"/>
              </a:rPr>
              <a:t>, and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hcaT</a:t>
            </a:r>
            <a:r>
              <a:rPr lang="en-US" dirty="0">
                <a:latin typeface="Arial" pitchFamily="34" charset="0"/>
                <a:cs typeface="Arial" pitchFamily="34" charset="0"/>
              </a:rPr>
              <a:t>; (3)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rrsA</a:t>
            </a:r>
            <a:r>
              <a:rPr lang="en-US" dirty="0">
                <a:latin typeface="Arial" pitchFamily="34" charset="0"/>
                <a:cs typeface="Arial" pitchFamily="34" charset="0"/>
              </a:rPr>
              <a:t> or (4)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ihfB</a:t>
            </a:r>
            <a:r>
              <a:rPr lang="en-US" dirty="0">
                <a:latin typeface="Arial" pitchFamily="34" charset="0"/>
                <a:cs typeface="Arial" pitchFamily="34" charset="0"/>
              </a:rPr>
              <a:t>. Normalization by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rrsA</a:t>
            </a:r>
            <a:r>
              <a:rPr lang="en-US" dirty="0">
                <a:latin typeface="Arial" pitchFamily="34" charset="0"/>
                <a:cs typeface="Arial" pitchFamily="34" charset="0"/>
              </a:rPr>
              <a:t> falsely identified the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downregulation</a:t>
            </a:r>
            <a:r>
              <a:rPr lang="en-US" dirty="0">
                <a:latin typeface="Arial" pitchFamily="34" charset="0"/>
                <a:cs typeface="Arial" pitchFamily="34" charset="0"/>
              </a:rPr>
              <a:t> of all target genes, and normalization by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ihfB</a:t>
            </a:r>
            <a:r>
              <a:rPr lang="en-US" dirty="0">
                <a:latin typeface="Arial" pitchFamily="34" charset="0"/>
                <a:cs typeface="Arial" pitchFamily="34" charset="0"/>
              </a:rPr>
              <a:t> falsely identified the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upregulation</a:t>
            </a:r>
            <a:r>
              <a:rPr lang="en-US" dirty="0">
                <a:latin typeface="Arial" pitchFamily="34" charset="0"/>
                <a:cs typeface="Arial" pitchFamily="34" charset="0"/>
              </a:rPr>
              <a:t> of all target genes. 2 is the threshold for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upregulation</a:t>
            </a:r>
            <a:r>
              <a:rPr lang="en-US" dirty="0">
                <a:latin typeface="Arial" pitchFamily="34" charset="0"/>
                <a:cs typeface="Arial" pitchFamily="34" charset="0"/>
              </a:rPr>
              <a:t> and 0.5 is the threshold for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downregulation</a:t>
            </a:r>
            <a:r>
              <a:rPr lang="en-US" dirty="0">
                <a:latin typeface="Arial" pitchFamily="34" charset="0"/>
                <a:cs typeface="Arial" pitchFamily="34" charset="0"/>
              </a:rPr>
              <a:t>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8</a:t>
            </a:fld>
            <a:endParaRPr 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Supplementary figure</a:t>
            </a:r>
            <a:r>
              <a:rPr lang="en-US" b="1" baseline="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b="1" baseline="0" dirty="0" smtClean="0">
                <a:latin typeface="Arial" pitchFamily="34" charset="0"/>
                <a:cs typeface="Arial" pitchFamily="34" charset="0"/>
              </a:rPr>
              <a:t>S</a:t>
            </a:r>
            <a:r>
              <a:rPr lang="en-US" b="1" dirty="0" smtClean="0">
                <a:latin typeface="Arial" pitchFamily="34" charset="0"/>
                <a:cs typeface="Arial" pitchFamily="34" charset="0"/>
              </a:rPr>
              <a:t>5 </a:t>
            </a:r>
            <a:r>
              <a:rPr lang="en-US" b="1" dirty="0" err="1">
                <a:latin typeface="Arial" pitchFamily="34" charset="0"/>
                <a:cs typeface="Arial" pitchFamily="34" charset="0"/>
              </a:rPr>
              <a:t>Upregulation</a:t>
            </a:r>
            <a:r>
              <a:rPr lang="en-US" b="1" dirty="0">
                <a:latin typeface="Arial" pitchFamily="34" charset="0"/>
                <a:cs typeface="Arial" pitchFamily="34" charset="0"/>
              </a:rPr>
              <a:t>  of rrsA transcript expression and </a:t>
            </a:r>
            <a:r>
              <a:rPr lang="en-US" b="1" dirty="0" err="1">
                <a:latin typeface="Arial" pitchFamily="34" charset="0"/>
                <a:cs typeface="Arial" pitchFamily="34" charset="0"/>
              </a:rPr>
              <a:t>downregulation</a:t>
            </a:r>
            <a:r>
              <a:rPr lang="en-US" b="1" dirty="0">
                <a:latin typeface="Arial" pitchFamily="34" charset="0"/>
                <a:cs typeface="Arial" pitchFamily="34" charset="0"/>
              </a:rPr>
              <a:t> of ihfB transcript expression upon IPTG induction in </a:t>
            </a:r>
            <a:r>
              <a:rPr lang="en-US" b="1" i="1" dirty="0">
                <a:latin typeface="Arial" pitchFamily="34" charset="0"/>
                <a:cs typeface="Arial" pitchFamily="34" charset="0"/>
              </a:rPr>
              <a:t>E. coli BL21 (DE3)</a:t>
            </a:r>
            <a:endParaRPr lang="en-US" b="1" dirty="0">
              <a:latin typeface="Arial" pitchFamily="34" charset="0"/>
              <a:cs typeface="Arial" pitchFamily="34" charset="0"/>
            </a:endParaRPr>
          </a:p>
          <a:p>
            <a:pPr defTabSz="990478">
              <a:defRPr/>
            </a:pPr>
            <a:r>
              <a:rPr lang="en-US" dirty="0">
                <a:latin typeface="Arial" pitchFamily="34" charset="0"/>
                <a:cs typeface="Arial" pitchFamily="34" charset="0"/>
              </a:rPr>
              <a:t>Fold changes in transcript expressions of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rrsA (A) </a:t>
            </a:r>
            <a:r>
              <a:rPr lang="en-US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ihfB (B) </a:t>
            </a:r>
            <a:r>
              <a:rPr lang="en-US" dirty="0">
                <a:latin typeface="Arial" pitchFamily="34" charset="0"/>
                <a:cs typeface="Arial" pitchFamily="34" charset="0"/>
              </a:rPr>
              <a:t>in IPTG induced cells relative to that of control were normalized by (1)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geometric mean of </a:t>
            </a:r>
            <a:r>
              <a:rPr lang="en-US" dirty="0" err="1" smtClean="0">
                <a:latin typeface="Arial" pitchFamily="34" charset="0"/>
                <a:cs typeface="Arial" pitchFamily="34" charset="0"/>
              </a:rPr>
              <a:t>idnT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en-US" dirty="0" err="1" smtClean="0">
                <a:latin typeface="Arial" pitchFamily="34" charset="0"/>
                <a:cs typeface="Arial" pitchFamily="34" charset="0"/>
              </a:rPr>
              <a:t>cysG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, and </a:t>
            </a:r>
            <a:r>
              <a:rPr lang="en-US" dirty="0" err="1" smtClean="0">
                <a:latin typeface="Arial" pitchFamily="34" charset="0"/>
                <a:cs typeface="Arial" pitchFamily="34" charset="0"/>
              </a:rPr>
              <a:t>hcaT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; </a:t>
            </a:r>
            <a:r>
              <a:rPr lang="en-US" dirty="0">
                <a:latin typeface="Arial" pitchFamily="34" charset="0"/>
                <a:cs typeface="Arial" pitchFamily="34" charset="0"/>
              </a:rPr>
              <a:t>(2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) geometric mean of top three most stable genes in the temperature subgroup; </a:t>
            </a:r>
            <a:r>
              <a:rPr lang="en-US" dirty="0">
                <a:latin typeface="Arial" pitchFamily="34" charset="0"/>
                <a:cs typeface="Arial" pitchFamily="34" charset="0"/>
              </a:rPr>
              <a:t>. 2 is the threshold for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upregulation</a:t>
            </a:r>
            <a:r>
              <a:rPr lang="en-US" dirty="0">
                <a:latin typeface="Arial" pitchFamily="34" charset="0"/>
                <a:cs typeface="Arial" pitchFamily="34" charset="0"/>
              </a:rPr>
              <a:t> and 0.5 is the threshold for </a:t>
            </a:r>
            <a:r>
              <a:rPr lang="en-US" dirty="0" err="1">
                <a:latin typeface="Arial" pitchFamily="34" charset="0"/>
                <a:cs typeface="Arial" pitchFamily="34" charset="0"/>
              </a:rPr>
              <a:t>downregulation</a:t>
            </a:r>
            <a:r>
              <a:rPr lang="en-US" dirty="0">
                <a:latin typeface="Arial" pitchFamily="34" charset="0"/>
                <a:cs typeface="Arial" pitchFamily="34" charset="0"/>
              </a:rPr>
              <a:t>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2E1ACD-3840-4B18-A204-B72641A20243}" type="slidenum">
              <a:rPr lang="en-US" smtClean="0"/>
              <a:pPr/>
              <a:t>9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rgbClr val="0000FF"/>
                </a:solidFill>
                <a:latin typeface="Comic Sans MS" pitchFamily="66" charset="0"/>
              </a:defRPr>
            </a:lvl1pPr>
          </a:lstStyle>
          <a:p>
            <a:fld id="{90D364AC-3DA5-40D4-A1E5-5B4BCB06FB43}" type="datetimeFigureOut">
              <a:rPr lang="en-US" smtClean="0"/>
              <a:pPr/>
              <a:t>4/9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rgbClr val="0000FF"/>
                </a:solidFill>
                <a:latin typeface="Comic Sans MS" pitchFamily="66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rgbClr val="0000FF"/>
                </a:solidFill>
                <a:latin typeface="Comic Sans MS" pitchFamily="66" charset="0"/>
              </a:defRPr>
            </a:lvl1pPr>
          </a:lstStyle>
          <a:p>
            <a:fld id="{03C6E5EF-CF2A-4E97-9CFE-5177B289A5C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spcBef>
          <a:spcPct val="0"/>
        </a:spcBef>
        <a:buNone/>
        <a:defRPr sz="2400" kern="1200">
          <a:solidFill>
            <a:srgbClr val="0000FF"/>
          </a:solidFill>
          <a:latin typeface="Comic Sans MS" pitchFamily="66" charset="0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rgbClr val="0000FF"/>
          </a:solidFill>
          <a:latin typeface="Comic Sans MS" pitchFamily="66" charset="0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1400" kern="1200">
          <a:solidFill>
            <a:srgbClr val="0000FF"/>
          </a:solidFill>
          <a:latin typeface="Comic Sans MS" pitchFamily="66" charset="0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1200" kern="1200">
          <a:solidFill>
            <a:srgbClr val="0000FF"/>
          </a:solidFill>
          <a:latin typeface="Comic Sans MS" pitchFamily="66" charset="0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1100" kern="1200">
          <a:solidFill>
            <a:srgbClr val="0000FF"/>
          </a:solidFill>
          <a:latin typeface="Comic Sans MS" pitchFamily="66" charset="0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1100" kern="1200">
          <a:solidFill>
            <a:srgbClr val="0000FF"/>
          </a:solidFill>
          <a:latin typeface="Comic Sans MS" pitchFamily="66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7.xml"/><Relationship Id="rId4" Type="http://schemas.openxmlformats.org/officeDocument/2006/relationships/chart" Target="../charts/chart1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0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14192"/>
            <a:ext cx="8929718" cy="230832"/>
          </a:xfrm>
          <a:prstGeom prst="rect">
            <a:avLst/>
          </a:prstGeom>
          <a:noFill/>
        </p:spPr>
        <p:txBody>
          <a:bodyPr wrap="square" lIns="45720" tIns="22860" rIns="45720" bIns="22860" rtlCol="0">
            <a:spAutoFit/>
          </a:bodyPr>
          <a:lstStyle/>
          <a:p>
            <a:endParaRPr lang="en-US" sz="1200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1371599" y="1196904"/>
          <a:ext cx="6400802" cy="4464192"/>
        </p:xfrm>
        <a:graphic>
          <a:graphicData uri="http://schemas.openxmlformats.org/drawingml/2006/table">
            <a:tbl>
              <a:tblPr/>
              <a:tblGrid>
                <a:gridCol w="622886"/>
                <a:gridCol w="1933542"/>
                <a:gridCol w="1975716"/>
                <a:gridCol w="622886"/>
                <a:gridCol w="622886"/>
                <a:gridCol w="622886"/>
              </a:tblGrid>
              <a:tr h="262664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ene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rimer-Forward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rimer-Reverse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ssay Efficiency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ntra-Assay CV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Inter-Assay CV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ygj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GCAAATACCATTCGTGACAA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ACTTAATCATCAGCGTATC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8.2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.1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5.27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bp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GAAGCCTATGGACCGAAAC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GCCGCCGAGAATGAGT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2.62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.0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.7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pfl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GTGCGAAATGTTTGCGTGAT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GTTCCAGAGCGTCAAG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6.8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.37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.21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xu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GACGCCAGAAACCATACAG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GCCCACTTTATCCCAATCC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8.8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.5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.3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ca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TGCTCGGCTTTCTCATC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ACCACGCTGACCAAC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5.35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.8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.58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ldnT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GTTTAGCGAAGAGGAGAT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AAACGGCGGCGATA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5.6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8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.0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etL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GAGCAGGATGAAGAGTCGTT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GTGGCTGGCGAAATCAA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7.1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.0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.5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gpQ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CGCTACCGTTGCTTTC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CCGTTAATGGTCCAGT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7.0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.4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.5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lv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CCATCCACGCTCTCAC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CTTCGCCCGCTTCAGTCA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.20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.3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.1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asn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GGGCGGGAATTAAAGCAAC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CCTGGCTGTGTACGAAGTG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4.30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38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.7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ACTGGAACACCTGACGCCTGAA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CTGGAAGAACACCTGTGGATT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.5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9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.82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yaj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TGGGCGGCTGGATTGA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TGCTGACATACGGCGGTT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4.05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.38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.1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xu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CGCCGAGTTTGCCGCTTT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CAGTTCACGCTCTTCCAGTT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8.37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15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.55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ys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TGTCGGCGGTGGTGATGT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TGCGGTGAACTGTGGAATAAAC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6.02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.27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.7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ygh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GGTTAAGTGGATTGCTGTG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TGGCAGGATCATCAGGAAC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7.02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.7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.5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hf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GGTTTCGGCAGTTTCT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GCAGTTCTTTACCAGGTTT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3.10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.4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.61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rnp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GGGCGGAGGGGAGGAAA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TCGGCGGTTTGCTCTCTGTT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4.47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.9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.5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ssr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GGGGATCAAGAGAGGTCAAA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GGACGGACACGCCACTAA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6.77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.8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5.35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rrs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CTTGCCATCGGATGTGCCCA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AGTGTGGCTGGTCATCCTCTCA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8.9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3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.9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sp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GAAGCGGTGCGAATAT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TTGCCAGAGATGATTTAAT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.18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75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3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spA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ATTATTAGGTGGTAA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TGAGTAAGCGTGGATA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9.00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.00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3.80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dxr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AGGTCTGGAATACATTGAA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ACTGCCGTCCTGATA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8.41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.01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11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dxs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AGGCCCGCAGTTCCTGCAT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GCAAACCGCCGCTACTTTT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3.2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.2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3.8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ispH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TCCAACTCCAACCGTCT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CTCTTTCACCCACTCTTC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0.63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.4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5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25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isp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GCTGGTGGCTGACATC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CGCTCTTCATTACCGATATT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1.10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06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0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3221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crt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TAAAGCGGGCGTTTCG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GCCAGCAGCATCAGC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4.69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.08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7.14%</a:t>
                      </a:r>
                    </a:p>
                  </a:txBody>
                  <a:tcPr marL="7296" marR="7296" marT="72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1397904980"/>
              </p:ext>
            </p:extLst>
          </p:nvPr>
        </p:nvGraphicFramePr>
        <p:xfrm>
          <a:off x="152400" y="228600"/>
          <a:ext cx="44005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/>
          <p:nvPr>
            <p:extLst>
              <p:ext uri="{D42A27DB-BD31-4B8C-83A1-F6EECF244321}">
                <p14:modId xmlns:p14="http://schemas.microsoft.com/office/powerpoint/2010/main" val="1190557690"/>
              </p:ext>
            </p:extLst>
          </p:nvPr>
        </p:nvGraphicFramePr>
        <p:xfrm>
          <a:off x="4572000" y="228600"/>
          <a:ext cx="440055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133600" y="304800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(A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629400" y="304800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(B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419600" y="64008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(C)</a:t>
            </a: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1724818"/>
              </p:ext>
            </p:extLst>
          </p:nvPr>
        </p:nvGraphicFramePr>
        <p:xfrm>
          <a:off x="2332533" y="3764280"/>
          <a:ext cx="4572000" cy="2636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8170672"/>
              </p:ext>
            </p:extLst>
          </p:nvPr>
        </p:nvGraphicFramePr>
        <p:xfrm>
          <a:off x="516714" y="1466660"/>
          <a:ext cx="8110572" cy="3924680"/>
        </p:xfrm>
        <a:graphic>
          <a:graphicData uri="http://schemas.openxmlformats.org/drawingml/2006/table">
            <a:tbl>
              <a:tblPr/>
              <a:tblGrid>
                <a:gridCol w="426872"/>
                <a:gridCol w="426872"/>
                <a:gridCol w="514914"/>
                <a:gridCol w="456220"/>
                <a:gridCol w="202764"/>
                <a:gridCol w="533591"/>
                <a:gridCol w="426872"/>
                <a:gridCol w="560269"/>
                <a:gridCol w="405529"/>
                <a:gridCol w="314819"/>
                <a:gridCol w="426872"/>
                <a:gridCol w="426872"/>
                <a:gridCol w="554934"/>
                <a:gridCol w="456220"/>
                <a:gridCol w="152073"/>
                <a:gridCol w="544262"/>
                <a:gridCol w="426872"/>
                <a:gridCol w="498908"/>
                <a:gridCol w="354837"/>
              </a:tblGrid>
              <a:tr h="171088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H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H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8°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°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312064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geNorm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M-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NormFinde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Stability 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eNorm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-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ormFinde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ability 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eNorm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-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ormFinde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ability 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1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geNorm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-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ormFinde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tability 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05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  <a:endParaRPr lang="en-GB" sz="1100" b="1" i="0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2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7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uxuR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63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  <a:endParaRPr lang="en-GB" sz="1100" b="1" i="1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ld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8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100" b="1" i="1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xu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6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ldnT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0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7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  <a:endParaRPr lang="en-GB" sz="1100" b="1" i="1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8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  <a:endParaRPr lang="en-GB" sz="1100" b="1" i="0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3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ldnT</a:t>
                      </a:r>
                      <a:endParaRPr lang="en-GB" sz="1100" b="1" i="1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  <a:endParaRPr lang="en-GB" sz="1100" b="1" i="0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3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7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xu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6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100" b="1" i="1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08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ld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3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4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ld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7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uxuR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6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100" b="1" i="0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4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ldnT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8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ldnT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xu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08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5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100" b="1" i="0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8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6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xu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8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12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100" b="1" i="1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9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7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  <a:endParaRPr lang="en-GB" sz="1100" b="1" i="0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9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xu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1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100" b="1" i="0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ldnT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5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8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  <a:endParaRPr lang="en-GB" sz="1100" b="1" i="1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100" b="1" i="0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9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17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met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2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hB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3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6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9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uxuR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4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  <a:endParaRPr lang="en-GB" sz="1100" b="1" i="1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2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3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4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9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7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4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5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4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uxuB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1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96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5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7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metL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5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xu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8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100" b="1" i="1" u="sng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xu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6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2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08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8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met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6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8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9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met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3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rnpB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3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asnA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08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8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28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92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6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asnA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7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11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2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hB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95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metL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8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8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met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.13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1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  <a:endParaRPr lang="en-GB" sz="11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02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99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3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93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9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.16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asnA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4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08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3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06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rnpB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rnp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99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9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1.18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sn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08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6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0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hB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9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2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ghB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6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gh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25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gh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48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sn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8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xu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7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gh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01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metL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ygh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9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metL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1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rnp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34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asnA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5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np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s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8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sn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02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1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8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np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4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rnpB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8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  <a:tr h="171088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38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rnpB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6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xu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xu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9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sng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26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  <a:endParaRPr lang="en-GB" sz="11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9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uxu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7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uxuB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7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1277674"/>
              </p:ext>
            </p:extLst>
          </p:nvPr>
        </p:nvGraphicFramePr>
        <p:xfrm>
          <a:off x="2895600" y="838200"/>
          <a:ext cx="3528392" cy="4328160"/>
        </p:xfrm>
        <a:graphic>
          <a:graphicData uri="http://schemas.openxmlformats.org/drawingml/2006/table">
            <a:tbl>
              <a:tblPr/>
              <a:tblGrid>
                <a:gridCol w="882098"/>
                <a:gridCol w="882098"/>
                <a:gridCol w="882098"/>
                <a:gridCol w="882098"/>
              </a:tblGrid>
              <a:tr h="238125"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8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DH10b-All sample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geNorm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1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M-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1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NormFinde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1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Stability Value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  <a:endParaRPr lang="en-GB" sz="14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56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cysG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21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58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23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  <a:endParaRPr lang="en-GB" sz="14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5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rrs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23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bp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0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gh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3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0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4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gh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1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llcY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6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4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hcaT</a:t>
                      </a:r>
                      <a:endParaRPr lang="en-GB" sz="14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8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gj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1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9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2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ssr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29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67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cc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idnT</a:t>
                      </a:r>
                      <a:endParaRPr lang="en-GB" sz="14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2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yajR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0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ugpQ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rnp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4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8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pflC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9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rnp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9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 dirty="0" err="1">
                          <a:solidFill>
                            <a:schemeClr val="tx1"/>
                          </a:solidFill>
                          <a:latin typeface="Calibri"/>
                        </a:rPr>
                        <a:t>idnT</a:t>
                      </a:r>
                      <a:endParaRPr lang="en-GB" sz="1400" b="0" i="1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39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met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9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metL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4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3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sn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0.70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asn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1.33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>
                          <a:solidFill>
                            <a:schemeClr val="tx1"/>
                          </a:solidFill>
                          <a:latin typeface="Calibri"/>
                        </a:rPr>
                        <a:t>ihfB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1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0.72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153208" y="1494312"/>
            <a:ext cx="4648200" cy="2656114"/>
            <a:chOff x="2362200" y="533400"/>
            <a:chExt cx="4648200" cy="2656114"/>
          </a:xfrm>
        </p:grpSpPr>
        <p:pic>
          <p:nvPicPr>
            <p:cNvPr id="3" name="Picture 2" descr="D:\Study\Research\Log\2010-04\2010-04-28 E. Coli Norm\2. Main Experimental data\Protein\Administrator 2010-05-27 20hr 31min Protein expression (100428) 4h and 8h.tif"/>
            <p:cNvPicPr>
              <a:picLocks noChangeAspect="1" noChangeArrowheads="1"/>
            </p:cNvPicPr>
            <p:nvPr/>
          </p:nvPicPr>
          <p:blipFill>
            <a:blip r:embed="rId3">
              <a:lum bright="30000" contrast="30000"/>
            </a:blip>
            <a:srcRect l="9837" t="22475" r="21777" b="28019"/>
            <a:stretch>
              <a:fillRect/>
            </a:stretch>
          </p:blipFill>
          <p:spPr bwMode="auto">
            <a:xfrm>
              <a:off x="2362200" y="533400"/>
              <a:ext cx="4648200" cy="2656114"/>
            </a:xfrm>
            <a:prstGeom prst="rect">
              <a:avLst/>
            </a:prstGeom>
            <a:noFill/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cxnSp>
          <p:nvCxnSpPr>
            <p:cNvPr id="4" name="Straight Connector 3"/>
            <p:cNvCxnSpPr/>
            <p:nvPr/>
          </p:nvCxnSpPr>
          <p:spPr>
            <a:xfrm>
              <a:off x="2362200" y="1676400"/>
              <a:ext cx="381000" cy="1588"/>
            </a:xfrm>
            <a:prstGeom prst="line">
              <a:avLst/>
            </a:prstGeom>
            <a:ln w="19050">
              <a:solidFill>
                <a:schemeClr val="tx1"/>
              </a:solidFill>
              <a:headEnd type="none" w="med" len="med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/>
            <p:cNvSpPr txBox="1"/>
            <p:nvPr/>
          </p:nvSpPr>
          <p:spPr>
            <a:xfrm>
              <a:off x="2843161" y="6096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175357" y="6096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507553" y="6096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839749" y="6096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171945" y="6096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5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504141" y="6096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6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36337" y="6096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7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168533" y="6096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8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500729" y="609600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9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832925" y="6096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250079" y="609600"/>
              <a:ext cx="3431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11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655816" y="6096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1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5302678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222621" y="633402"/>
            <a:ext cx="8698758" cy="5591196"/>
            <a:chOff x="-33867" y="428604"/>
            <a:chExt cx="8698758" cy="5591196"/>
          </a:xfrm>
        </p:grpSpPr>
        <p:grpSp>
          <p:nvGrpSpPr>
            <p:cNvPr id="2" name="Group 1"/>
            <p:cNvGrpSpPr/>
            <p:nvPr/>
          </p:nvGrpSpPr>
          <p:grpSpPr>
            <a:xfrm>
              <a:off x="-32" y="428604"/>
              <a:ext cx="4238936" cy="2749087"/>
              <a:chOff x="-32" y="428604"/>
              <a:chExt cx="4238936" cy="2749087"/>
            </a:xfrm>
          </p:grpSpPr>
          <p:pic>
            <p:nvPicPr>
              <p:cNvPr id="2049" name="Picture 1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-32" y="434491"/>
                <a:ext cx="4238936" cy="2743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4" name="TextBox 3"/>
              <p:cNvSpPr txBox="1"/>
              <p:nvPr/>
            </p:nvSpPr>
            <p:spPr>
              <a:xfrm>
                <a:off x="1155023" y="428604"/>
                <a:ext cx="19288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Subgroup 4H</a:t>
                </a:r>
                <a:endParaRPr lang="en-GB" sz="16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endParaRPr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4343400" y="428604"/>
              <a:ext cx="4321491" cy="2749087"/>
              <a:chOff x="4343400" y="428604"/>
              <a:chExt cx="4321491" cy="2749087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4343400" y="434491"/>
                <a:ext cx="4321491" cy="2743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8" name="TextBox 7"/>
              <p:cNvSpPr txBox="1"/>
              <p:nvPr/>
            </p:nvSpPr>
            <p:spPr>
              <a:xfrm>
                <a:off x="5539732" y="428604"/>
                <a:ext cx="19288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S</a:t>
                </a:r>
                <a:r>
                  <a:rPr lang="en-GB" sz="1600" b="1" dirty="0" smtClean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ubgroup 8H</a:t>
                </a:r>
                <a:endParaRPr lang="en-GB" sz="1600" b="1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endParaRPr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-33867" y="3276600"/>
              <a:ext cx="4267854" cy="2743200"/>
              <a:chOff x="-33867" y="3276600"/>
              <a:chExt cx="4267854" cy="2743200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5"/>
              <a:srcRect/>
              <a:stretch>
                <a:fillRect/>
              </a:stretch>
            </p:blipFill>
            <p:spPr bwMode="auto">
              <a:xfrm>
                <a:off x="-33867" y="3276600"/>
                <a:ext cx="4267854" cy="2743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1135647" y="3276600"/>
                <a:ext cx="19288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Subgroup 28°C </a:t>
                </a:r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4338510" y="3276600"/>
              <a:ext cx="4280185" cy="2743200"/>
              <a:chOff x="4338510" y="3276600"/>
              <a:chExt cx="4280185" cy="2743200"/>
            </a:xfrm>
          </p:grpSpPr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6"/>
              <a:srcRect/>
              <a:stretch>
                <a:fillRect/>
              </a:stretch>
            </p:blipFill>
            <p:spPr bwMode="auto">
              <a:xfrm>
                <a:off x="4338510" y="3276600"/>
                <a:ext cx="4280185" cy="27432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5514189" y="3276600"/>
                <a:ext cx="192882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600" b="1" dirty="0"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</a:rPr>
                  <a:t>Subgroup 37°C</a:t>
                </a: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>
            <p:extLst>
              <p:ext uri="{D42A27DB-BD31-4B8C-83A1-F6EECF244321}">
                <p14:modId xmlns:p14="http://schemas.microsoft.com/office/powerpoint/2010/main" val="1690335287"/>
              </p:ext>
            </p:extLst>
          </p:nvPr>
        </p:nvGraphicFramePr>
        <p:xfrm>
          <a:off x="0" y="142876"/>
          <a:ext cx="9144000" cy="30003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/>
          <p:cNvGraphicFramePr/>
          <p:nvPr>
            <p:extLst>
              <p:ext uri="{D42A27DB-BD31-4B8C-83A1-F6EECF244321}">
                <p14:modId xmlns:p14="http://schemas.microsoft.com/office/powerpoint/2010/main" val="2824297123"/>
              </p:ext>
            </p:extLst>
          </p:nvPr>
        </p:nvGraphicFramePr>
        <p:xfrm>
          <a:off x="0" y="3143248"/>
          <a:ext cx="9144000" cy="33575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214678" y="71414"/>
            <a:ext cx="32861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>
                <a:latin typeface="Arial" pitchFamily="34" charset="0"/>
                <a:cs typeface="Arial" pitchFamily="34" charset="0"/>
              </a:rPr>
              <a:t>geNorm Stability Ranking</a:t>
            </a:r>
            <a:endParaRPr lang="en-GB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214678" y="3202544"/>
            <a:ext cx="32861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b="1" dirty="0" smtClean="0">
                <a:latin typeface="Arial" pitchFamily="34" charset="0"/>
                <a:cs typeface="Arial" pitchFamily="34" charset="0"/>
              </a:rPr>
              <a:t>NormFinder Stability Ranking</a:t>
            </a:r>
            <a:endParaRPr lang="en-GB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-71462"/>
            <a:ext cx="10715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M-Value</a:t>
            </a:r>
            <a:endParaRPr lang="en-GB" sz="16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-32" y="2947570"/>
            <a:ext cx="15716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 smtClean="0"/>
              <a:t>Stability-Value</a:t>
            </a:r>
            <a:endParaRPr lang="en-GB" sz="1600" b="1" dirty="0"/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6400800"/>
            <a:ext cx="184731" cy="369332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90980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4377075" y="304800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(A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419600" y="642860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(B)</a:t>
            </a:r>
          </a:p>
        </p:txBody>
      </p:sp>
      <p:graphicFrame>
        <p:nvGraphicFramePr>
          <p:cNvPr id="13" name="Chart 12"/>
          <p:cNvGraphicFramePr/>
          <p:nvPr>
            <p:extLst>
              <p:ext uri="{D42A27DB-BD31-4B8C-83A1-F6EECF244321}">
                <p14:modId xmlns:p14="http://schemas.microsoft.com/office/powerpoint/2010/main" val="4168487645"/>
              </p:ext>
            </p:extLst>
          </p:nvPr>
        </p:nvGraphicFramePr>
        <p:xfrm>
          <a:off x="0" y="228600"/>
          <a:ext cx="4565888" cy="273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/>
          <p:cNvGraphicFramePr/>
          <p:nvPr>
            <p:extLst>
              <p:ext uri="{D42A27DB-BD31-4B8C-83A1-F6EECF244321}">
                <p14:modId xmlns:p14="http://schemas.microsoft.com/office/powerpoint/2010/main" val="2410317801"/>
              </p:ext>
            </p:extLst>
          </p:nvPr>
        </p:nvGraphicFramePr>
        <p:xfrm>
          <a:off x="4572000" y="228600"/>
          <a:ext cx="4572000" cy="2745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/>
          <p:nvPr>
            <p:extLst>
              <p:ext uri="{D42A27DB-BD31-4B8C-83A1-F6EECF244321}">
                <p14:modId xmlns:p14="http://schemas.microsoft.com/office/powerpoint/2010/main" val="612487772"/>
              </p:ext>
            </p:extLst>
          </p:nvPr>
        </p:nvGraphicFramePr>
        <p:xfrm>
          <a:off x="0" y="3606959"/>
          <a:ext cx="4565888" cy="273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" name="Chart 15"/>
          <p:cNvGraphicFramePr/>
          <p:nvPr>
            <p:extLst>
              <p:ext uri="{D42A27DB-BD31-4B8C-83A1-F6EECF244321}">
                <p14:modId xmlns:p14="http://schemas.microsoft.com/office/powerpoint/2010/main" val="2602634800"/>
              </p:ext>
            </p:extLst>
          </p:nvPr>
        </p:nvGraphicFramePr>
        <p:xfrm>
          <a:off x="4572000" y="3606959"/>
          <a:ext cx="4572000" cy="2745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419600" y="63246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(D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373067" y="297180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(C)</a:t>
            </a:r>
          </a:p>
        </p:txBody>
      </p:sp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3923858204"/>
              </p:ext>
            </p:extLst>
          </p:nvPr>
        </p:nvGraphicFramePr>
        <p:xfrm>
          <a:off x="0" y="228600"/>
          <a:ext cx="4565888" cy="273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1214700820"/>
              </p:ext>
            </p:extLst>
          </p:nvPr>
        </p:nvGraphicFramePr>
        <p:xfrm>
          <a:off x="4572000" y="228600"/>
          <a:ext cx="4572000" cy="2745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Chart 12"/>
          <p:cNvGraphicFramePr/>
          <p:nvPr>
            <p:extLst>
              <p:ext uri="{D42A27DB-BD31-4B8C-83A1-F6EECF244321}">
                <p14:modId xmlns:p14="http://schemas.microsoft.com/office/powerpoint/2010/main" val="3252352790"/>
              </p:ext>
            </p:extLst>
          </p:nvPr>
        </p:nvGraphicFramePr>
        <p:xfrm>
          <a:off x="0" y="3590569"/>
          <a:ext cx="4565888" cy="273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4" name="Chart 13"/>
          <p:cNvGraphicFramePr/>
          <p:nvPr>
            <p:extLst>
              <p:ext uri="{D42A27DB-BD31-4B8C-83A1-F6EECF244321}">
                <p14:modId xmlns:p14="http://schemas.microsoft.com/office/powerpoint/2010/main" val="3921640354"/>
              </p:ext>
            </p:extLst>
          </p:nvPr>
        </p:nvGraphicFramePr>
        <p:xfrm>
          <a:off x="4572000" y="3581400"/>
          <a:ext cx="4572000" cy="27454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/>
          <p:nvPr>
            <p:extLst>
              <p:ext uri="{D42A27DB-BD31-4B8C-83A1-F6EECF244321}">
                <p14:modId xmlns:p14="http://schemas.microsoft.com/office/powerpoint/2010/main" val="2930698108"/>
              </p:ext>
            </p:extLst>
          </p:nvPr>
        </p:nvGraphicFramePr>
        <p:xfrm>
          <a:off x="0" y="304800"/>
          <a:ext cx="4565888" cy="273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2438532176"/>
              </p:ext>
            </p:extLst>
          </p:nvPr>
        </p:nvGraphicFramePr>
        <p:xfrm>
          <a:off x="4578112" y="304800"/>
          <a:ext cx="4565888" cy="273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2686679381"/>
              </p:ext>
            </p:extLst>
          </p:nvPr>
        </p:nvGraphicFramePr>
        <p:xfrm>
          <a:off x="0" y="3588327"/>
          <a:ext cx="4565888" cy="273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Chart 14"/>
          <p:cNvGraphicFramePr/>
          <p:nvPr>
            <p:extLst>
              <p:ext uri="{D42A27DB-BD31-4B8C-83A1-F6EECF244321}">
                <p14:modId xmlns:p14="http://schemas.microsoft.com/office/powerpoint/2010/main" val="2455904022"/>
              </p:ext>
            </p:extLst>
          </p:nvPr>
        </p:nvGraphicFramePr>
        <p:xfrm>
          <a:off x="4578112" y="3588327"/>
          <a:ext cx="4565888" cy="27362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4377075" y="3124200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(A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377075" y="650480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itchFamily="34" charset="0"/>
                <a:cs typeface="Arial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30078858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3175">
          <a:solidFill>
            <a:schemeClr val="accent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9050">
          <a:headEnd type="none" w="med" len="med"/>
          <a:tailEnd type="stealth" w="lg" len="lg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200" dirty="0" err="1" smtClean="0">
            <a:solidFill>
              <a:srgbClr val="0000FF"/>
            </a:solidFill>
            <a:latin typeface="Comic Sans MS" pitchFamily="66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16131</TotalTime>
  <Words>1837</Words>
  <Application>Microsoft Office PowerPoint</Application>
  <PresentationFormat>On-screen Show (4:3)</PresentationFormat>
  <Paragraphs>647</Paragraphs>
  <Slides>10</Slides>
  <Notes>1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blank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ng</dc:creator>
  <cp:lastModifiedBy>Kang</cp:lastModifiedBy>
  <cp:revision>114</cp:revision>
  <cp:lastPrinted>2010-10-21T03:18:45Z</cp:lastPrinted>
  <dcterms:created xsi:type="dcterms:W3CDTF">2010-03-26T00:07:56Z</dcterms:created>
  <dcterms:modified xsi:type="dcterms:W3CDTF">2011-04-09T07:06:01Z</dcterms:modified>
</cp:coreProperties>
</file>